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6"/>
  </p:notesMasterIdLst>
  <p:sldIdLst>
    <p:sldId id="256" r:id="rId2"/>
    <p:sldId id="257" r:id="rId3"/>
    <p:sldId id="258" r:id="rId4"/>
    <p:sldId id="259" r:id="rId5"/>
  </p:sldIdLst>
  <p:sldSz cx="10058400" cy="8229600"/>
  <p:notesSz cx="10058400" cy="82296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DA5022-2503-4E07-89F0-A79A1B44E879}" v="1" dt="2023-07-06T05:38:41.540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4005" autoAdjust="0"/>
  </p:normalViewPr>
  <p:slideViewPr>
    <p:cSldViewPr>
      <p:cViewPr varScale="1">
        <p:scale>
          <a:sx n="79" d="100"/>
          <a:sy n="79" d="100"/>
        </p:scale>
        <p:origin x="2322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59275" cy="4127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97538" y="0"/>
            <a:ext cx="4359275" cy="4127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C24033-D55F-486B-A104-302E2AF71EE4}" type="datetimeFigureOut">
              <a:rPr lang="en-NZ" smtClean="0"/>
              <a:t>6/07/2023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332163" y="1028700"/>
            <a:ext cx="3394075" cy="27781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1006475" y="3960813"/>
            <a:ext cx="8045450" cy="32400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7816850"/>
            <a:ext cx="4359275" cy="4127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97538" y="7816850"/>
            <a:ext cx="4359275" cy="4127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685C89-27B4-435B-8920-A477F04F345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9569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ungal network of GTD escape vines based on Pearson's correlation analysis. Each node, colored by its phylum, represents an ASV. </a:t>
            </a:r>
          </a:p>
          <a:p>
            <a:r>
              <a:rPr lang="en-US" dirty="0"/>
              <a:t>Their size is proportional to the degree of the individual ASV. </a:t>
            </a:r>
          </a:p>
          <a:p>
            <a:r>
              <a:rPr lang="en-US" dirty="0"/>
              <a:t>Connections between nodes signify strong (r &gt; 0.6) and statistically significant (p &lt; 0.05) correlations.</a:t>
            </a:r>
            <a:endParaRPr lang="en-NZ" dirty="0"/>
          </a:p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685C89-27B4-435B-8920-A477F04F345B}" type="slidenum">
              <a:rPr lang="en-NZ" smtClean="0"/>
              <a:t>1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8118058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ungal network of diseased vines based on Pearson's correlation analysis. Each node, colored by its phylum, represents an ASV. </a:t>
            </a:r>
          </a:p>
          <a:p>
            <a:r>
              <a:rPr lang="en-US" dirty="0"/>
              <a:t>Their size is proportional to the degree of the individual ASV. </a:t>
            </a:r>
          </a:p>
          <a:p>
            <a:r>
              <a:rPr lang="en-US" dirty="0"/>
              <a:t>Connections between nodes signify strong (r &gt; 0.6) and statistically significant (p &lt; 0.05) correlations.</a:t>
            </a:r>
            <a:endParaRPr lang="en-NZ" dirty="0"/>
          </a:p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685C89-27B4-435B-8920-A477F04F345B}" type="slidenum">
              <a:rPr lang="en-NZ" smtClean="0"/>
              <a:t>2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807704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acterial network of diseased vines based on Pearson's correlation analysis. Each node, colored by its phylum, represents an ASV. </a:t>
            </a:r>
          </a:p>
          <a:p>
            <a:r>
              <a:rPr lang="en-US" dirty="0"/>
              <a:t>Their size is proportional to the degree of the individual ASV. </a:t>
            </a:r>
          </a:p>
          <a:p>
            <a:r>
              <a:rPr lang="en-US" dirty="0"/>
              <a:t>Connections between nodes signify strong (r &gt; 0.6) and statistically significant (p &lt; 0.05) correlations.</a:t>
            </a:r>
            <a:endParaRPr lang="en-NZ" dirty="0"/>
          </a:p>
          <a:p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685C89-27B4-435B-8920-A477F04F345B}" type="slidenum">
              <a:rPr lang="en-NZ" smtClean="0"/>
              <a:t>3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197062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acterial network of GTD escape vines based on Pearson's correlation analysis. Each node, colored by its phylum, represents an ASV. </a:t>
            </a:r>
          </a:p>
          <a:p>
            <a:r>
              <a:rPr lang="en-US" dirty="0"/>
              <a:t>Their size is proportional to the degree of the individual ASV. </a:t>
            </a:r>
          </a:p>
          <a:p>
            <a:r>
              <a:rPr lang="en-US" dirty="0"/>
              <a:t>Connections between nodes signify strong (r &gt; 0.6) and statistically significant (p &lt; 0.05) correlations.</a:t>
            </a:r>
            <a:endParaRPr lang="en-NZ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685C89-27B4-435B-8920-A477F04F345B}" type="slidenum">
              <a:rPr lang="en-NZ" smtClean="0"/>
              <a:t>4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963764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754380" y="2551176"/>
            <a:ext cx="8549640" cy="172821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508760" y="4608576"/>
            <a:ext cx="7040880" cy="20574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502920" y="1892808"/>
            <a:ext cx="4375404" cy="543153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5180076" y="1892808"/>
            <a:ext cx="4375404" cy="543153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502920" y="329184"/>
            <a:ext cx="9052560" cy="131673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502920" y="1892808"/>
            <a:ext cx="9052560" cy="5431536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419856" y="7653528"/>
            <a:ext cx="3218688" cy="4114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502920" y="7653528"/>
            <a:ext cx="2313432" cy="4114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7/6/2023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7242048" y="7653528"/>
            <a:ext cx="2313432" cy="4114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396938" y="596709"/>
            <a:ext cx="6586347" cy="7234935"/>
          </a:xfrm>
          <a:prstGeom prst="rect">
            <a:avLst/>
          </a:prstGeom>
        </p:spPr>
      </p:pic>
      <p:pic>
        <p:nvPicPr>
          <p:cNvPr id="3" name="object 3"/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7082091" y="3572954"/>
            <a:ext cx="1176274" cy="631952"/>
          </a:xfrm>
          <a:prstGeom prst="rect">
            <a:avLst/>
          </a:prstGeom>
        </p:spPr>
      </p:pic>
      <p:grpSp>
        <p:nvGrpSpPr>
          <p:cNvPr id="4" name="object 4"/>
          <p:cNvGrpSpPr/>
          <p:nvPr/>
        </p:nvGrpSpPr>
        <p:grpSpPr>
          <a:xfrm>
            <a:off x="8814307" y="2970529"/>
            <a:ext cx="219710" cy="878205"/>
            <a:chOff x="8814307" y="2970529"/>
            <a:chExt cx="219710" cy="878205"/>
          </a:xfrm>
        </p:grpSpPr>
        <p:sp>
          <p:nvSpPr>
            <p:cNvPr id="5" name="object 5"/>
            <p:cNvSpPr/>
            <p:nvPr/>
          </p:nvSpPr>
          <p:spPr>
            <a:xfrm>
              <a:off x="8814307" y="2970529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8908668" y="3064890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5" h="31114">
                  <a:moveTo>
                    <a:pt x="0" y="15367"/>
                  </a:moveTo>
                  <a:lnTo>
                    <a:pt x="0" y="6985"/>
                  </a:lnTo>
                  <a:lnTo>
                    <a:pt x="6984" y="0"/>
                  </a:lnTo>
                  <a:lnTo>
                    <a:pt x="15366" y="0"/>
                  </a:lnTo>
                  <a:lnTo>
                    <a:pt x="23749" y="0"/>
                  </a:lnTo>
                  <a:lnTo>
                    <a:pt x="30733" y="6985"/>
                  </a:lnTo>
                  <a:lnTo>
                    <a:pt x="30733" y="15367"/>
                  </a:lnTo>
                  <a:lnTo>
                    <a:pt x="30733" y="23749"/>
                  </a:lnTo>
                  <a:lnTo>
                    <a:pt x="23749" y="30734"/>
                  </a:lnTo>
                  <a:lnTo>
                    <a:pt x="15366" y="30734"/>
                  </a:lnTo>
                  <a:lnTo>
                    <a:pt x="6984" y="30734"/>
                  </a:lnTo>
                  <a:lnTo>
                    <a:pt x="0" y="23749"/>
                  </a:lnTo>
                  <a:lnTo>
                    <a:pt x="0" y="1536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8814307" y="3189985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8879077" y="3254755"/>
              <a:ext cx="90170" cy="90170"/>
            </a:xfrm>
            <a:custGeom>
              <a:avLst/>
              <a:gdLst/>
              <a:ahLst/>
              <a:cxnLst/>
              <a:rect l="l" t="t" r="r" b="b"/>
              <a:pathLst>
                <a:path w="90170" h="90170">
                  <a:moveTo>
                    <a:pt x="0" y="44958"/>
                  </a:moveTo>
                  <a:lnTo>
                    <a:pt x="3542" y="27485"/>
                  </a:lnTo>
                  <a:lnTo>
                    <a:pt x="13192" y="13192"/>
                  </a:lnTo>
                  <a:lnTo>
                    <a:pt x="27485" y="3542"/>
                  </a:lnTo>
                  <a:lnTo>
                    <a:pt x="44957" y="0"/>
                  </a:lnTo>
                  <a:lnTo>
                    <a:pt x="62430" y="3542"/>
                  </a:lnTo>
                  <a:lnTo>
                    <a:pt x="76723" y="13192"/>
                  </a:lnTo>
                  <a:lnTo>
                    <a:pt x="86373" y="27485"/>
                  </a:lnTo>
                  <a:lnTo>
                    <a:pt x="89916" y="44958"/>
                  </a:lnTo>
                  <a:lnTo>
                    <a:pt x="86373" y="62430"/>
                  </a:lnTo>
                  <a:lnTo>
                    <a:pt x="76723" y="76723"/>
                  </a:lnTo>
                  <a:lnTo>
                    <a:pt x="62430" y="86373"/>
                  </a:lnTo>
                  <a:lnTo>
                    <a:pt x="44957" y="89916"/>
                  </a:lnTo>
                  <a:lnTo>
                    <a:pt x="27485" y="86373"/>
                  </a:lnTo>
                  <a:lnTo>
                    <a:pt x="13192" y="76723"/>
                  </a:lnTo>
                  <a:lnTo>
                    <a:pt x="3542" y="62430"/>
                  </a:lnTo>
                  <a:lnTo>
                    <a:pt x="0" y="44958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8814307" y="340944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8866885" y="3462019"/>
              <a:ext cx="114300" cy="114300"/>
            </a:xfrm>
            <a:custGeom>
              <a:avLst/>
              <a:gdLst/>
              <a:ahLst/>
              <a:cxnLst/>
              <a:rect l="l" t="t" r="r" b="b"/>
              <a:pathLst>
                <a:path w="114300" h="114300">
                  <a:moveTo>
                    <a:pt x="0" y="57150"/>
                  </a:moveTo>
                  <a:lnTo>
                    <a:pt x="4500" y="34932"/>
                  </a:lnTo>
                  <a:lnTo>
                    <a:pt x="16764" y="16763"/>
                  </a:lnTo>
                  <a:lnTo>
                    <a:pt x="34932" y="4500"/>
                  </a:lnTo>
                  <a:lnTo>
                    <a:pt x="57150" y="0"/>
                  </a:lnTo>
                  <a:lnTo>
                    <a:pt x="79367" y="4500"/>
                  </a:lnTo>
                  <a:lnTo>
                    <a:pt x="97535" y="16763"/>
                  </a:lnTo>
                  <a:lnTo>
                    <a:pt x="109799" y="34932"/>
                  </a:lnTo>
                  <a:lnTo>
                    <a:pt x="114300" y="57150"/>
                  </a:lnTo>
                  <a:lnTo>
                    <a:pt x="109799" y="79367"/>
                  </a:lnTo>
                  <a:lnTo>
                    <a:pt x="97535" y="97536"/>
                  </a:lnTo>
                  <a:lnTo>
                    <a:pt x="79367" y="109799"/>
                  </a:lnTo>
                  <a:lnTo>
                    <a:pt x="57150" y="114300"/>
                  </a:lnTo>
                  <a:lnTo>
                    <a:pt x="34932" y="109799"/>
                  </a:lnTo>
                  <a:lnTo>
                    <a:pt x="16764" y="97536"/>
                  </a:lnTo>
                  <a:lnTo>
                    <a:pt x="4500" y="79367"/>
                  </a:lnTo>
                  <a:lnTo>
                    <a:pt x="0" y="57150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8814307" y="3628897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8857487" y="3672077"/>
              <a:ext cx="133350" cy="133350"/>
            </a:xfrm>
            <a:custGeom>
              <a:avLst/>
              <a:gdLst/>
              <a:ahLst/>
              <a:cxnLst/>
              <a:rect l="l" t="t" r="r" b="b"/>
              <a:pathLst>
                <a:path w="133350" h="133350">
                  <a:moveTo>
                    <a:pt x="0" y="66548"/>
                  </a:moveTo>
                  <a:lnTo>
                    <a:pt x="5254" y="40719"/>
                  </a:lnTo>
                  <a:lnTo>
                    <a:pt x="19557" y="19558"/>
                  </a:lnTo>
                  <a:lnTo>
                    <a:pt x="40719" y="5254"/>
                  </a:lnTo>
                  <a:lnTo>
                    <a:pt x="66547" y="0"/>
                  </a:lnTo>
                  <a:lnTo>
                    <a:pt x="92376" y="5254"/>
                  </a:lnTo>
                  <a:lnTo>
                    <a:pt x="113537" y="19558"/>
                  </a:lnTo>
                  <a:lnTo>
                    <a:pt x="127841" y="40719"/>
                  </a:lnTo>
                  <a:lnTo>
                    <a:pt x="133095" y="66548"/>
                  </a:lnTo>
                  <a:lnTo>
                    <a:pt x="127841" y="92376"/>
                  </a:lnTo>
                  <a:lnTo>
                    <a:pt x="113537" y="113537"/>
                  </a:lnTo>
                  <a:lnTo>
                    <a:pt x="92376" y="127841"/>
                  </a:lnTo>
                  <a:lnTo>
                    <a:pt x="66547" y="133096"/>
                  </a:lnTo>
                  <a:lnTo>
                    <a:pt x="40719" y="127841"/>
                  </a:lnTo>
                  <a:lnTo>
                    <a:pt x="19557" y="113537"/>
                  </a:lnTo>
                  <a:lnTo>
                    <a:pt x="5254" y="92376"/>
                  </a:lnTo>
                  <a:lnTo>
                    <a:pt x="0" y="66548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3" name="object 13"/>
          <p:cNvGrpSpPr/>
          <p:nvPr/>
        </p:nvGrpSpPr>
        <p:grpSpPr>
          <a:xfrm>
            <a:off x="8814307" y="4327397"/>
            <a:ext cx="219710" cy="658495"/>
            <a:chOff x="8814307" y="4327397"/>
            <a:chExt cx="219710" cy="658495"/>
          </a:xfrm>
        </p:grpSpPr>
        <p:sp>
          <p:nvSpPr>
            <p:cNvPr id="14" name="object 14"/>
            <p:cNvSpPr/>
            <p:nvPr/>
          </p:nvSpPr>
          <p:spPr>
            <a:xfrm>
              <a:off x="8814307" y="4327397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8899143" y="4412233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24891" y="0"/>
                  </a:moveTo>
                  <a:lnTo>
                    <a:pt x="15216" y="1960"/>
                  </a:lnTo>
                  <a:lnTo>
                    <a:pt x="7302" y="7302"/>
                  </a:lnTo>
                  <a:lnTo>
                    <a:pt x="1960" y="15216"/>
                  </a:lnTo>
                  <a:lnTo>
                    <a:pt x="0" y="24891"/>
                  </a:lnTo>
                  <a:lnTo>
                    <a:pt x="1960" y="34494"/>
                  </a:lnTo>
                  <a:lnTo>
                    <a:pt x="7302" y="42370"/>
                  </a:lnTo>
                  <a:lnTo>
                    <a:pt x="15216" y="47698"/>
                  </a:lnTo>
                  <a:lnTo>
                    <a:pt x="24891" y="49656"/>
                  </a:lnTo>
                  <a:lnTo>
                    <a:pt x="34494" y="47698"/>
                  </a:lnTo>
                  <a:lnTo>
                    <a:pt x="42370" y="42370"/>
                  </a:lnTo>
                  <a:lnTo>
                    <a:pt x="47698" y="34494"/>
                  </a:lnTo>
                  <a:lnTo>
                    <a:pt x="49656" y="24891"/>
                  </a:lnTo>
                  <a:lnTo>
                    <a:pt x="47698" y="15216"/>
                  </a:lnTo>
                  <a:lnTo>
                    <a:pt x="42370" y="7302"/>
                  </a:lnTo>
                  <a:lnTo>
                    <a:pt x="34494" y="1960"/>
                  </a:lnTo>
                  <a:lnTo>
                    <a:pt x="24891" y="0"/>
                  </a:lnTo>
                  <a:close/>
                </a:path>
              </a:pathLst>
            </a:custGeom>
            <a:solidFill>
              <a:srgbClr val="F8766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8899143" y="4412233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0" y="24891"/>
                  </a:moveTo>
                  <a:lnTo>
                    <a:pt x="1960" y="15216"/>
                  </a:lnTo>
                  <a:lnTo>
                    <a:pt x="7302" y="7302"/>
                  </a:lnTo>
                  <a:lnTo>
                    <a:pt x="15216" y="1960"/>
                  </a:lnTo>
                  <a:lnTo>
                    <a:pt x="24891" y="0"/>
                  </a:lnTo>
                  <a:lnTo>
                    <a:pt x="34494" y="1960"/>
                  </a:lnTo>
                  <a:lnTo>
                    <a:pt x="42370" y="7302"/>
                  </a:lnTo>
                  <a:lnTo>
                    <a:pt x="47698" y="15216"/>
                  </a:lnTo>
                  <a:lnTo>
                    <a:pt x="49656" y="24891"/>
                  </a:lnTo>
                  <a:lnTo>
                    <a:pt x="47698" y="34494"/>
                  </a:lnTo>
                  <a:lnTo>
                    <a:pt x="42370" y="42370"/>
                  </a:lnTo>
                  <a:lnTo>
                    <a:pt x="34494" y="47698"/>
                  </a:lnTo>
                  <a:lnTo>
                    <a:pt x="24891" y="49656"/>
                  </a:lnTo>
                  <a:lnTo>
                    <a:pt x="15216" y="47698"/>
                  </a:lnTo>
                  <a:lnTo>
                    <a:pt x="7302" y="42370"/>
                  </a:lnTo>
                  <a:lnTo>
                    <a:pt x="1960" y="34494"/>
                  </a:lnTo>
                  <a:lnTo>
                    <a:pt x="0" y="24891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8814307" y="4546853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8899143" y="4631689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24891" y="0"/>
                  </a:moveTo>
                  <a:lnTo>
                    <a:pt x="15216" y="1960"/>
                  </a:lnTo>
                  <a:lnTo>
                    <a:pt x="7302" y="7302"/>
                  </a:lnTo>
                  <a:lnTo>
                    <a:pt x="1960" y="15216"/>
                  </a:lnTo>
                  <a:lnTo>
                    <a:pt x="0" y="24892"/>
                  </a:lnTo>
                  <a:lnTo>
                    <a:pt x="1960" y="34494"/>
                  </a:lnTo>
                  <a:lnTo>
                    <a:pt x="7302" y="42370"/>
                  </a:lnTo>
                  <a:lnTo>
                    <a:pt x="15216" y="47698"/>
                  </a:lnTo>
                  <a:lnTo>
                    <a:pt x="24891" y="49657"/>
                  </a:lnTo>
                  <a:lnTo>
                    <a:pt x="34494" y="47698"/>
                  </a:lnTo>
                  <a:lnTo>
                    <a:pt x="42370" y="42370"/>
                  </a:lnTo>
                  <a:lnTo>
                    <a:pt x="47698" y="34494"/>
                  </a:lnTo>
                  <a:lnTo>
                    <a:pt x="49656" y="24892"/>
                  </a:lnTo>
                  <a:lnTo>
                    <a:pt x="47698" y="15216"/>
                  </a:lnTo>
                  <a:lnTo>
                    <a:pt x="42370" y="7302"/>
                  </a:lnTo>
                  <a:lnTo>
                    <a:pt x="34494" y="1960"/>
                  </a:lnTo>
                  <a:lnTo>
                    <a:pt x="24891" y="0"/>
                  </a:lnTo>
                  <a:close/>
                </a:path>
              </a:pathLst>
            </a:custGeom>
            <a:solidFill>
              <a:srgbClr val="00BA3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8899143" y="4631689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0" y="24892"/>
                  </a:moveTo>
                  <a:lnTo>
                    <a:pt x="1960" y="15216"/>
                  </a:lnTo>
                  <a:lnTo>
                    <a:pt x="7302" y="7302"/>
                  </a:lnTo>
                  <a:lnTo>
                    <a:pt x="15216" y="1960"/>
                  </a:lnTo>
                  <a:lnTo>
                    <a:pt x="24891" y="0"/>
                  </a:lnTo>
                  <a:lnTo>
                    <a:pt x="34494" y="1960"/>
                  </a:lnTo>
                  <a:lnTo>
                    <a:pt x="42370" y="7302"/>
                  </a:lnTo>
                  <a:lnTo>
                    <a:pt x="47698" y="15216"/>
                  </a:lnTo>
                  <a:lnTo>
                    <a:pt x="49656" y="24892"/>
                  </a:lnTo>
                  <a:lnTo>
                    <a:pt x="47698" y="34494"/>
                  </a:lnTo>
                  <a:lnTo>
                    <a:pt x="42370" y="42370"/>
                  </a:lnTo>
                  <a:lnTo>
                    <a:pt x="34494" y="47698"/>
                  </a:lnTo>
                  <a:lnTo>
                    <a:pt x="24891" y="49657"/>
                  </a:lnTo>
                  <a:lnTo>
                    <a:pt x="15216" y="47698"/>
                  </a:lnTo>
                  <a:lnTo>
                    <a:pt x="7302" y="42370"/>
                  </a:lnTo>
                  <a:lnTo>
                    <a:pt x="1960" y="34494"/>
                  </a:lnTo>
                  <a:lnTo>
                    <a:pt x="0" y="24892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8814307" y="4766309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8899143" y="4851145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24891" y="0"/>
                  </a:moveTo>
                  <a:lnTo>
                    <a:pt x="15216" y="1960"/>
                  </a:lnTo>
                  <a:lnTo>
                    <a:pt x="7302" y="7302"/>
                  </a:lnTo>
                  <a:lnTo>
                    <a:pt x="1960" y="15216"/>
                  </a:lnTo>
                  <a:lnTo>
                    <a:pt x="0" y="24891"/>
                  </a:lnTo>
                  <a:lnTo>
                    <a:pt x="1960" y="34494"/>
                  </a:lnTo>
                  <a:lnTo>
                    <a:pt x="7302" y="42370"/>
                  </a:lnTo>
                  <a:lnTo>
                    <a:pt x="15216" y="47698"/>
                  </a:lnTo>
                  <a:lnTo>
                    <a:pt x="24891" y="49656"/>
                  </a:lnTo>
                  <a:lnTo>
                    <a:pt x="34494" y="47698"/>
                  </a:lnTo>
                  <a:lnTo>
                    <a:pt x="42370" y="42370"/>
                  </a:lnTo>
                  <a:lnTo>
                    <a:pt x="47698" y="34494"/>
                  </a:lnTo>
                  <a:lnTo>
                    <a:pt x="49656" y="24891"/>
                  </a:lnTo>
                  <a:lnTo>
                    <a:pt x="47698" y="15216"/>
                  </a:lnTo>
                  <a:lnTo>
                    <a:pt x="42370" y="7302"/>
                  </a:lnTo>
                  <a:lnTo>
                    <a:pt x="34494" y="1960"/>
                  </a:lnTo>
                  <a:lnTo>
                    <a:pt x="24891" y="0"/>
                  </a:lnTo>
                  <a:close/>
                </a:path>
              </a:pathLst>
            </a:custGeom>
            <a:solidFill>
              <a:srgbClr val="619C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8899143" y="4851145"/>
              <a:ext cx="50165" cy="50165"/>
            </a:xfrm>
            <a:custGeom>
              <a:avLst/>
              <a:gdLst/>
              <a:ahLst/>
              <a:cxnLst/>
              <a:rect l="l" t="t" r="r" b="b"/>
              <a:pathLst>
                <a:path w="50165" h="50164">
                  <a:moveTo>
                    <a:pt x="0" y="24891"/>
                  </a:moveTo>
                  <a:lnTo>
                    <a:pt x="1960" y="15216"/>
                  </a:lnTo>
                  <a:lnTo>
                    <a:pt x="7302" y="7302"/>
                  </a:lnTo>
                  <a:lnTo>
                    <a:pt x="15216" y="1960"/>
                  </a:lnTo>
                  <a:lnTo>
                    <a:pt x="24891" y="0"/>
                  </a:lnTo>
                  <a:lnTo>
                    <a:pt x="34494" y="1960"/>
                  </a:lnTo>
                  <a:lnTo>
                    <a:pt x="42370" y="7302"/>
                  </a:lnTo>
                  <a:lnTo>
                    <a:pt x="47698" y="15216"/>
                  </a:lnTo>
                  <a:lnTo>
                    <a:pt x="49656" y="24891"/>
                  </a:lnTo>
                  <a:lnTo>
                    <a:pt x="47698" y="34494"/>
                  </a:lnTo>
                  <a:lnTo>
                    <a:pt x="42370" y="42370"/>
                  </a:lnTo>
                  <a:lnTo>
                    <a:pt x="34494" y="47698"/>
                  </a:lnTo>
                  <a:lnTo>
                    <a:pt x="24891" y="49656"/>
                  </a:lnTo>
                  <a:lnTo>
                    <a:pt x="15216" y="47698"/>
                  </a:lnTo>
                  <a:lnTo>
                    <a:pt x="7302" y="42370"/>
                  </a:lnTo>
                  <a:lnTo>
                    <a:pt x="1960" y="34494"/>
                  </a:lnTo>
                  <a:lnTo>
                    <a:pt x="0" y="24891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3" name="object 23"/>
          <p:cNvGrpSpPr/>
          <p:nvPr/>
        </p:nvGrpSpPr>
        <p:grpSpPr>
          <a:xfrm>
            <a:off x="8814307" y="5464683"/>
            <a:ext cx="219710" cy="219710"/>
            <a:chOff x="8814307" y="5464683"/>
            <a:chExt cx="219710" cy="219710"/>
          </a:xfrm>
        </p:grpSpPr>
        <p:sp>
          <p:nvSpPr>
            <p:cNvPr id="24" name="object 24"/>
            <p:cNvSpPr/>
            <p:nvPr/>
          </p:nvSpPr>
          <p:spPr>
            <a:xfrm>
              <a:off x="8814307" y="5464683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8836278" y="5574411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3175">
              <a:solidFill>
                <a:srgbClr val="6D98B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26" name="object 26"/>
          <p:cNvSpPr txBox="1"/>
          <p:nvPr/>
        </p:nvSpPr>
        <p:spPr>
          <a:xfrm>
            <a:off x="8801607" y="2733166"/>
            <a:ext cx="1130935" cy="291782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5" dirty="0">
                <a:latin typeface="Arial"/>
                <a:cs typeface="Arial"/>
              </a:rPr>
              <a:t>igraph.degree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1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30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100" spc="-10" dirty="0">
                <a:latin typeface="Arial"/>
                <a:cs typeface="Arial"/>
              </a:rPr>
              <a:t>Phylum</a:t>
            </a:r>
            <a:endParaRPr sz="1100">
              <a:latin typeface="Arial"/>
              <a:cs typeface="Arial"/>
            </a:endParaRPr>
          </a:p>
          <a:p>
            <a:pPr marL="301625" marR="5080">
              <a:lnSpc>
                <a:spcPct val="160000"/>
              </a:lnSpc>
              <a:spcBef>
                <a:spcPts val="90"/>
              </a:spcBef>
            </a:pPr>
            <a:r>
              <a:rPr sz="900" spc="-5" dirty="0">
                <a:latin typeface="Arial"/>
                <a:cs typeface="Arial"/>
              </a:rPr>
              <a:t>Ascomycota </a:t>
            </a:r>
            <a:r>
              <a:rPr sz="900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Basidiomycota </a:t>
            </a:r>
            <a:r>
              <a:rPr sz="900" dirty="0">
                <a:latin typeface="Arial"/>
                <a:cs typeface="Arial"/>
              </a:rPr>
              <a:t> C</a:t>
            </a:r>
            <a:r>
              <a:rPr sz="900" spc="-30" dirty="0">
                <a:latin typeface="Arial"/>
                <a:cs typeface="Arial"/>
              </a:rPr>
              <a:t>h</a:t>
            </a:r>
            <a:r>
              <a:rPr sz="900" dirty="0">
                <a:latin typeface="Arial"/>
                <a:cs typeface="Arial"/>
              </a:rPr>
              <a:t>yt</a:t>
            </a:r>
            <a:r>
              <a:rPr sz="900" spc="10" dirty="0">
                <a:latin typeface="Arial"/>
                <a:cs typeface="Arial"/>
              </a:rPr>
              <a:t>r</a:t>
            </a:r>
            <a:r>
              <a:rPr sz="900" dirty="0">
                <a:latin typeface="Arial"/>
                <a:cs typeface="Arial"/>
              </a:rPr>
              <a:t>idio</a:t>
            </a:r>
            <a:r>
              <a:rPr sz="900" spc="-15" dirty="0">
                <a:latin typeface="Arial"/>
                <a:cs typeface="Arial"/>
              </a:rPr>
              <a:t>m</a:t>
            </a:r>
            <a:r>
              <a:rPr sz="900" dirty="0">
                <a:latin typeface="Arial"/>
                <a:cs typeface="Arial"/>
              </a:rPr>
              <a:t>ycota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100" dirty="0">
                <a:latin typeface="Arial"/>
                <a:cs typeface="Arial"/>
              </a:rPr>
              <a:t>cor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+</a:t>
            </a:r>
            <a:endParaRPr sz="900">
              <a:latin typeface="Arial"/>
              <a:cs typeface="Arial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3526154" y="10286"/>
            <a:ext cx="2569846" cy="2128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300" dirty="0" err="1">
                <a:latin typeface="Arial"/>
                <a:cs typeface="Arial"/>
              </a:rPr>
              <a:t>Fungi_</a:t>
            </a:r>
            <a:r>
              <a:rPr sz="1300" dirty="0" err="1">
                <a:latin typeface="Arial"/>
                <a:cs typeface="Arial"/>
              </a:rPr>
              <a:t>GTD</a:t>
            </a:r>
            <a:r>
              <a:rPr sz="1300" spc="-8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escape_network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19163" y="620839"/>
            <a:ext cx="7234428" cy="7234301"/>
          </a:xfrm>
          <a:prstGeom prst="rect">
            <a:avLst/>
          </a:prstGeom>
        </p:spPr>
      </p:pic>
      <p:grpSp>
        <p:nvGrpSpPr>
          <p:cNvPr id="3" name="object 3"/>
          <p:cNvGrpSpPr/>
          <p:nvPr/>
        </p:nvGrpSpPr>
        <p:grpSpPr>
          <a:xfrm>
            <a:off x="7804213" y="4068381"/>
            <a:ext cx="520065" cy="466090"/>
            <a:chOff x="7804213" y="4068381"/>
            <a:chExt cx="520065" cy="466090"/>
          </a:xfrm>
        </p:grpSpPr>
        <p:sp>
          <p:nvSpPr>
            <p:cNvPr id="4" name="object 4"/>
            <p:cNvSpPr/>
            <p:nvPr/>
          </p:nvSpPr>
          <p:spPr>
            <a:xfrm>
              <a:off x="7839583" y="4103751"/>
              <a:ext cx="448945" cy="418465"/>
            </a:xfrm>
            <a:custGeom>
              <a:avLst/>
              <a:gdLst/>
              <a:ahLst/>
              <a:cxnLst/>
              <a:rect l="l" t="t" r="r" b="b"/>
              <a:pathLst>
                <a:path w="448945" h="418464">
                  <a:moveTo>
                    <a:pt x="448945" y="346456"/>
                  </a:moveTo>
                  <a:lnTo>
                    <a:pt x="446786" y="344170"/>
                  </a:lnTo>
                  <a:lnTo>
                    <a:pt x="436752" y="334010"/>
                  </a:lnTo>
                  <a:lnTo>
                    <a:pt x="424052" y="321183"/>
                  </a:lnTo>
                  <a:lnTo>
                    <a:pt x="413131" y="309752"/>
                  </a:lnTo>
                  <a:lnTo>
                    <a:pt x="386588" y="278129"/>
                  </a:lnTo>
                  <a:lnTo>
                    <a:pt x="363982" y="246634"/>
                  </a:lnTo>
                  <a:lnTo>
                    <a:pt x="344043" y="213360"/>
                  </a:lnTo>
                  <a:lnTo>
                    <a:pt x="325755" y="176784"/>
                  </a:lnTo>
                  <a:lnTo>
                    <a:pt x="307086" y="128650"/>
                  </a:lnTo>
                  <a:lnTo>
                    <a:pt x="296545" y="91439"/>
                  </a:lnTo>
                  <a:lnTo>
                    <a:pt x="288290" y="50926"/>
                  </a:lnTo>
                  <a:lnTo>
                    <a:pt x="282321" y="3175"/>
                  </a:lnTo>
                  <a:lnTo>
                    <a:pt x="281813" y="0"/>
                  </a:lnTo>
                </a:path>
                <a:path w="448945" h="418464">
                  <a:moveTo>
                    <a:pt x="281813" y="0"/>
                  </a:moveTo>
                  <a:lnTo>
                    <a:pt x="280797" y="3428"/>
                  </a:lnTo>
                  <a:lnTo>
                    <a:pt x="276098" y="19303"/>
                  </a:lnTo>
                  <a:lnTo>
                    <a:pt x="269875" y="40386"/>
                  </a:lnTo>
                  <a:lnTo>
                    <a:pt x="264033" y="59054"/>
                  </a:lnTo>
                  <a:lnTo>
                    <a:pt x="250825" y="94996"/>
                  </a:lnTo>
                  <a:lnTo>
                    <a:pt x="232410" y="136398"/>
                  </a:lnTo>
                  <a:lnTo>
                    <a:pt x="206883" y="183134"/>
                  </a:lnTo>
                  <a:lnTo>
                    <a:pt x="181610" y="222250"/>
                  </a:lnTo>
                  <a:lnTo>
                    <a:pt x="150749" y="262382"/>
                  </a:lnTo>
                  <a:lnTo>
                    <a:pt x="115316" y="301625"/>
                  </a:lnTo>
                  <a:lnTo>
                    <a:pt x="82296" y="332739"/>
                  </a:lnTo>
                  <a:lnTo>
                    <a:pt x="66675" y="346075"/>
                  </a:lnTo>
                  <a:lnTo>
                    <a:pt x="53086" y="356870"/>
                  </a:lnTo>
                  <a:lnTo>
                    <a:pt x="37846" y="368173"/>
                  </a:lnTo>
                  <a:lnTo>
                    <a:pt x="20193" y="380873"/>
                  </a:lnTo>
                  <a:lnTo>
                    <a:pt x="4952" y="391795"/>
                  </a:lnTo>
                  <a:lnTo>
                    <a:pt x="0" y="395350"/>
                  </a:lnTo>
                </a:path>
                <a:path w="448945" h="418464">
                  <a:moveTo>
                    <a:pt x="448945" y="346456"/>
                  </a:moveTo>
                  <a:lnTo>
                    <a:pt x="445643" y="347979"/>
                  </a:lnTo>
                  <a:lnTo>
                    <a:pt x="430657" y="354964"/>
                  </a:lnTo>
                  <a:lnTo>
                    <a:pt x="411607" y="363982"/>
                  </a:lnTo>
                  <a:lnTo>
                    <a:pt x="394716" y="371475"/>
                  </a:lnTo>
                  <a:lnTo>
                    <a:pt x="379095" y="377951"/>
                  </a:lnTo>
                  <a:lnTo>
                    <a:pt x="378714" y="378078"/>
                  </a:lnTo>
                  <a:lnTo>
                    <a:pt x="363220" y="383794"/>
                  </a:lnTo>
                  <a:lnTo>
                    <a:pt x="321564" y="397001"/>
                  </a:lnTo>
                  <a:lnTo>
                    <a:pt x="274320" y="407924"/>
                  </a:lnTo>
                  <a:lnTo>
                    <a:pt x="229743" y="414654"/>
                  </a:lnTo>
                  <a:lnTo>
                    <a:pt x="229235" y="414782"/>
                  </a:lnTo>
                  <a:lnTo>
                    <a:pt x="212851" y="416178"/>
                  </a:lnTo>
                  <a:lnTo>
                    <a:pt x="197866" y="417195"/>
                  </a:lnTo>
                  <a:lnTo>
                    <a:pt x="184150" y="417702"/>
                  </a:lnTo>
                  <a:lnTo>
                    <a:pt x="169164" y="418084"/>
                  </a:lnTo>
                  <a:lnTo>
                    <a:pt x="152781" y="418084"/>
                  </a:lnTo>
                  <a:lnTo>
                    <a:pt x="152273" y="418084"/>
                  </a:lnTo>
                  <a:lnTo>
                    <a:pt x="107188" y="415036"/>
                  </a:lnTo>
                  <a:lnTo>
                    <a:pt x="75946" y="411225"/>
                  </a:lnTo>
                  <a:lnTo>
                    <a:pt x="75565" y="411225"/>
                  </a:lnTo>
                  <a:lnTo>
                    <a:pt x="20320" y="399923"/>
                  </a:lnTo>
                  <a:lnTo>
                    <a:pt x="0" y="395350"/>
                  </a:lnTo>
                </a:path>
              </a:pathLst>
            </a:custGeom>
            <a:ln w="3175">
              <a:solidFill>
                <a:srgbClr val="6D98B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pic>
          <p:nvPicPr>
            <p:cNvPr id="5" name="object 5"/>
            <p:cNvPicPr/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8086153" y="4068381"/>
              <a:ext cx="70612" cy="70739"/>
            </a:xfrm>
            <a:prstGeom prst="rect">
              <a:avLst/>
            </a:prstGeom>
          </p:spPr>
        </p:pic>
        <p:pic>
          <p:nvPicPr>
            <p:cNvPr id="6" name="object 6"/>
            <p:cNvPicPr/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7804213" y="4463859"/>
              <a:ext cx="70739" cy="70612"/>
            </a:xfrm>
            <a:prstGeom prst="rect">
              <a:avLst/>
            </a:prstGeom>
          </p:spPr>
        </p:pic>
        <p:pic>
          <p:nvPicPr>
            <p:cNvPr id="7" name="object 7"/>
            <p:cNvPicPr/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8253285" y="4414837"/>
              <a:ext cx="70612" cy="70738"/>
            </a:xfrm>
            <a:prstGeom prst="rect">
              <a:avLst/>
            </a:prstGeom>
          </p:spPr>
        </p:pic>
      </p:grpSp>
      <p:grpSp>
        <p:nvGrpSpPr>
          <p:cNvPr id="8" name="object 8"/>
          <p:cNvGrpSpPr/>
          <p:nvPr/>
        </p:nvGrpSpPr>
        <p:grpSpPr>
          <a:xfrm>
            <a:off x="8888730" y="2860801"/>
            <a:ext cx="219710" cy="219710"/>
            <a:chOff x="8888730" y="2860801"/>
            <a:chExt cx="219710" cy="219710"/>
          </a:xfrm>
        </p:grpSpPr>
        <p:sp>
          <p:nvSpPr>
            <p:cNvPr id="9" name="object 9"/>
            <p:cNvSpPr/>
            <p:nvPr/>
          </p:nvSpPr>
          <p:spPr>
            <a:xfrm>
              <a:off x="8888730" y="286080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8910701" y="297052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>
                  <a:moveTo>
                    <a:pt x="0" y="0"/>
                  </a:moveTo>
                  <a:lnTo>
                    <a:pt x="175514" y="0"/>
                  </a:lnTo>
                </a:path>
              </a:pathLst>
            </a:custGeom>
            <a:ln w="3175">
              <a:solidFill>
                <a:srgbClr val="6D98B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11" name="object 11"/>
          <p:cNvGrpSpPr/>
          <p:nvPr/>
        </p:nvGrpSpPr>
        <p:grpSpPr>
          <a:xfrm>
            <a:off x="8888730" y="3559302"/>
            <a:ext cx="219710" cy="1316990"/>
            <a:chOff x="8888730" y="3559302"/>
            <a:chExt cx="219710" cy="1316990"/>
          </a:xfrm>
        </p:grpSpPr>
        <p:sp>
          <p:nvSpPr>
            <p:cNvPr id="12" name="object 12"/>
            <p:cNvSpPr/>
            <p:nvPr/>
          </p:nvSpPr>
          <p:spPr>
            <a:xfrm>
              <a:off x="8888730" y="355930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8983091" y="3653663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5" h="31114">
                  <a:moveTo>
                    <a:pt x="0" y="15366"/>
                  </a:moveTo>
                  <a:lnTo>
                    <a:pt x="0" y="6858"/>
                  </a:lnTo>
                  <a:lnTo>
                    <a:pt x="6857" y="0"/>
                  </a:lnTo>
                  <a:lnTo>
                    <a:pt x="15366" y="0"/>
                  </a:lnTo>
                  <a:lnTo>
                    <a:pt x="23749" y="0"/>
                  </a:lnTo>
                  <a:lnTo>
                    <a:pt x="30733" y="6858"/>
                  </a:lnTo>
                  <a:lnTo>
                    <a:pt x="30733" y="15366"/>
                  </a:lnTo>
                  <a:lnTo>
                    <a:pt x="30733" y="23749"/>
                  </a:lnTo>
                  <a:lnTo>
                    <a:pt x="23749" y="30607"/>
                  </a:lnTo>
                  <a:lnTo>
                    <a:pt x="15366" y="30607"/>
                  </a:lnTo>
                  <a:lnTo>
                    <a:pt x="6857" y="30607"/>
                  </a:lnTo>
                  <a:lnTo>
                    <a:pt x="0" y="23749"/>
                  </a:lnTo>
                  <a:lnTo>
                    <a:pt x="0" y="15366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8888730" y="3778758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8958580" y="3848608"/>
              <a:ext cx="80010" cy="80010"/>
            </a:xfrm>
            <a:custGeom>
              <a:avLst/>
              <a:gdLst/>
              <a:ahLst/>
              <a:cxnLst/>
              <a:rect l="l" t="t" r="r" b="b"/>
              <a:pathLst>
                <a:path w="80009" h="80010">
                  <a:moveTo>
                    <a:pt x="0" y="39877"/>
                  </a:moveTo>
                  <a:lnTo>
                    <a:pt x="3141" y="24378"/>
                  </a:lnTo>
                  <a:lnTo>
                    <a:pt x="11699" y="11699"/>
                  </a:lnTo>
                  <a:lnTo>
                    <a:pt x="24378" y="3141"/>
                  </a:lnTo>
                  <a:lnTo>
                    <a:pt x="39877" y="0"/>
                  </a:lnTo>
                  <a:lnTo>
                    <a:pt x="55324" y="3141"/>
                  </a:lnTo>
                  <a:lnTo>
                    <a:pt x="68008" y="11699"/>
                  </a:lnTo>
                  <a:lnTo>
                    <a:pt x="76596" y="24378"/>
                  </a:lnTo>
                  <a:lnTo>
                    <a:pt x="79755" y="39877"/>
                  </a:lnTo>
                  <a:lnTo>
                    <a:pt x="76596" y="55304"/>
                  </a:lnTo>
                  <a:lnTo>
                    <a:pt x="68008" y="67944"/>
                  </a:lnTo>
                  <a:lnTo>
                    <a:pt x="55324" y="76489"/>
                  </a:lnTo>
                  <a:lnTo>
                    <a:pt x="39877" y="79628"/>
                  </a:lnTo>
                  <a:lnTo>
                    <a:pt x="24378" y="76489"/>
                  </a:lnTo>
                  <a:lnTo>
                    <a:pt x="11699" y="67944"/>
                  </a:lnTo>
                  <a:lnTo>
                    <a:pt x="3141" y="55304"/>
                  </a:lnTo>
                  <a:lnTo>
                    <a:pt x="0" y="3987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8888730" y="399821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8948420" y="4057904"/>
              <a:ext cx="100330" cy="100330"/>
            </a:xfrm>
            <a:custGeom>
              <a:avLst/>
              <a:gdLst/>
              <a:ahLst/>
              <a:cxnLst/>
              <a:rect l="l" t="t" r="r" b="b"/>
              <a:pathLst>
                <a:path w="100329" h="100329">
                  <a:moveTo>
                    <a:pt x="0" y="50037"/>
                  </a:moveTo>
                  <a:lnTo>
                    <a:pt x="3942" y="30593"/>
                  </a:lnTo>
                  <a:lnTo>
                    <a:pt x="14684" y="14684"/>
                  </a:lnTo>
                  <a:lnTo>
                    <a:pt x="30593" y="3942"/>
                  </a:lnTo>
                  <a:lnTo>
                    <a:pt x="50037" y="0"/>
                  </a:lnTo>
                  <a:lnTo>
                    <a:pt x="69409" y="3942"/>
                  </a:lnTo>
                  <a:lnTo>
                    <a:pt x="85280" y="14684"/>
                  </a:lnTo>
                  <a:lnTo>
                    <a:pt x="96008" y="30593"/>
                  </a:lnTo>
                  <a:lnTo>
                    <a:pt x="99949" y="50037"/>
                  </a:lnTo>
                  <a:lnTo>
                    <a:pt x="96008" y="69409"/>
                  </a:lnTo>
                  <a:lnTo>
                    <a:pt x="85280" y="85280"/>
                  </a:lnTo>
                  <a:lnTo>
                    <a:pt x="69409" y="96008"/>
                  </a:lnTo>
                  <a:lnTo>
                    <a:pt x="50037" y="99949"/>
                  </a:lnTo>
                  <a:lnTo>
                    <a:pt x="30593" y="96008"/>
                  </a:lnTo>
                  <a:lnTo>
                    <a:pt x="14684" y="85280"/>
                  </a:lnTo>
                  <a:lnTo>
                    <a:pt x="3942" y="69409"/>
                  </a:lnTo>
                  <a:lnTo>
                    <a:pt x="0" y="5003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8888730" y="4217670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8940673" y="4269613"/>
              <a:ext cx="115570" cy="115570"/>
            </a:xfrm>
            <a:custGeom>
              <a:avLst/>
              <a:gdLst/>
              <a:ahLst/>
              <a:cxnLst/>
              <a:rect l="l" t="t" r="r" b="b"/>
              <a:pathLst>
                <a:path w="115570" h="115570">
                  <a:moveTo>
                    <a:pt x="0" y="57785"/>
                  </a:moveTo>
                  <a:lnTo>
                    <a:pt x="4564" y="35307"/>
                  </a:lnTo>
                  <a:lnTo>
                    <a:pt x="16986" y="16938"/>
                  </a:lnTo>
                  <a:lnTo>
                    <a:pt x="35361" y="4546"/>
                  </a:lnTo>
                  <a:lnTo>
                    <a:pt x="57784" y="0"/>
                  </a:lnTo>
                  <a:lnTo>
                    <a:pt x="80208" y="4546"/>
                  </a:lnTo>
                  <a:lnTo>
                    <a:pt x="98583" y="16938"/>
                  </a:lnTo>
                  <a:lnTo>
                    <a:pt x="111005" y="35307"/>
                  </a:lnTo>
                  <a:lnTo>
                    <a:pt x="115570" y="57785"/>
                  </a:lnTo>
                  <a:lnTo>
                    <a:pt x="111005" y="80188"/>
                  </a:lnTo>
                  <a:lnTo>
                    <a:pt x="98583" y="98520"/>
                  </a:lnTo>
                  <a:lnTo>
                    <a:pt x="80208" y="110898"/>
                  </a:lnTo>
                  <a:lnTo>
                    <a:pt x="57784" y="115442"/>
                  </a:lnTo>
                  <a:lnTo>
                    <a:pt x="35361" y="110898"/>
                  </a:lnTo>
                  <a:lnTo>
                    <a:pt x="16986" y="98520"/>
                  </a:lnTo>
                  <a:lnTo>
                    <a:pt x="4564" y="80188"/>
                  </a:lnTo>
                  <a:lnTo>
                    <a:pt x="0" y="5778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8888730" y="443712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8934069" y="4482465"/>
              <a:ext cx="128905" cy="128905"/>
            </a:xfrm>
            <a:custGeom>
              <a:avLst/>
              <a:gdLst/>
              <a:ahLst/>
              <a:cxnLst/>
              <a:rect l="l" t="t" r="r" b="b"/>
              <a:pathLst>
                <a:path w="128904" h="128904">
                  <a:moveTo>
                    <a:pt x="0" y="64388"/>
                  </a:moveTo>
                  <a:lnTo>
                    <a:pt x="5078" y="39379"/>
                  </a:lnTo>
                  <a:lnTo>
                    <a:pt x="18907" y="18907"/>
                  </a:lnTo>
                  <a:lnTo>
                    <a:pt x="39379" y="5078"/>
                  </a:lnTo>
                  <a:lnTo>
                    <a:pt x="64388" y="0"/>
                  </a:lnTo>
                  <a:lnTo>
                    <a:pt x="89324" y="5078"/>
                  </a:lnTo>
                  <a:lnTo>
                    <a:pt x="109759" y="18907"/>
                  </a:lnTo>
                  <a:lnTo>
                    <a:pt x="123574" y="39379"/>
                  </a:lnTo>
                  <a:lnTo>
                    <a:pt x="128650" y="64388"/>
                  </a:lnTo>
                  <a:lnTo>
                    <a:pt x="123574" y="89324"/>
                  </a:lnTo>
                  <a:lnTo>
                    <a:pt x="109759" y="109759"/>
                  </a:lnTo>
                  <a:lnTo>
                    <a:pt x="89324" y="123574"/>
                  </a:lnTo>
                  <a:lnTo>
                    <a:pt x="64388" y="128650"/>
                  </a:lnTo>
                  <a:lnTo>
                    <a:pt x="39379" y="123574"/>
                  </a:lnTo>
                  <a:lnTo>
                    <a:pt x="18907" y="109759"/>
                  </a:lnTo>
                  <a:lnTo>
                    <a:pt x="5078" y="89324"/>
                  </a:lnTo>
                  <a:lnTo>
                    <a:pt x="0" y="64388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8888730" y="465658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8928354" y="4696206"/>
              <a:ext cx="140335" cy="140335"/>
            </a:xfrm>
            <a:custGeom>
              <a:avLst/>
              <a:gdLst/>
              <a:ahLst/>
              <a:cxnLst/>
              <a:rect l="l" t="t" r="r" b="b"/>
              <a:pathLst>
                <a:path w="140334" h="140335">
                  <a:moveTo>
                    <a:pt x="0" y="70104"/>
                  </a:moveTo>
                  <a:lnTo>
                    <a:pt x="5524" y="42862"/>
                  </a:lnTo>
                  <a:lnTo>
                    <a:pt x="20573" y="20574"/>
                  </a:lnTo>
                  <a:lnTo>
                    <a:pt x="42862" y="5524"/>
                  </a:lnTo>
                  <a:lnTo>
                    <a:pt x="70103" y="0"/>
                  </a:lnTo>
                  <a:lnTo>
                    <a:pt x="97291" y="5524"/>
                  </a:lnTo>
                  <a:lnTo>
                    <a:pt x="119586" y="20574"/>
                  </a:lnTo>
                  <a:lnTo>
                    <a:pt x="134665" y="42862"/>
                  </a:lnTo>
                  <a:lnTo>
                    <a:pt x="140207" y="70104"/>
                  </a:lnTo>
                  <a:lnTo>
                    <a:pt x="134665" y="97291"/>
                  </a:lnTo>
                  <a:lnTo>
                    <a:pt x="119586" y="119586"/>
                  </a:lnTo>
                  <a:lnTo>
                    <a:pt x="97291" y="134665"/>
                  </a:lnTo>
                  <a:lnTo>
                    <a:pt x="70103" y="140208"/>
                  </a:lnTo>
                  <a:lnTo>
                    <a:pt x="42862" y="134665"/>
                  </a:lnTo>
                  <a:lnTo>
                    <a:pt x="20574" y="119586"/>
                  </a:lnTo>
                  <a:lnTo>
                    <a:pt x="5524" y="97291"/>
                  </a:lnTo>
                  <a:lnTo>
                    <a:pt x="0" y="7010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pic>
        <p:nvPicPr>
          <p:cNvPr id="24" name="object 24"/>
          <p:cNvPicPr/>
          <p:nvPr/>
        </p:nvPicPr>
        <p:blipFill>
          <a:blip r:embed="rId7" cstate="print"/>
          <a:stretch>
            <a:fillRect/>
          </a:stretch>
        </p:blipFill>
        <p:spPr>
          <a:xfrm>
            <a:off x="8888730" y="5354954"/>
            <a:ext cx="219455" cy="438912"/>
          </a:xfrm>
          <a:prstGeom prst="rect">
            <a:avLst/>
          </a:prstGeom>
        </p:spPr>
      </p:pic>
      <p:sp>
        <p:nvSpPr>
          <p:cNvPr id="25" name="object 25"/>
          <p:cNvSpPr txBox="1"/>
          <p:nvPr/>
        </p:nvSpPr>
        <p:spPr>
          <a:xfrm>
            <a:off x="8876030" y="2623439"/>
            <a:ext cx="1056640" cy="31375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dirty="0">
                <a:latin typeface="Arial"/>
                <a:cs typeface="Arial"/>
              </a:rPr>
              <a:t>cor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+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100" spc="-5" dirty="0">
                <a:latin typeface="Arial"/>
                <a:cs typeface="Arial"/>
              </a:rPr>
              <a:t>igraph.degree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5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1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15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25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100" spc="-10" dirty="0">
                <a:latin typeface="Arial"/>
                <a:cs typeface="Arial"/>
              </a:rPr>
              <a:t>Phylum</a:t>
            </a:r>
            <a:endParaRPr sz="1100">
              <a:latin typeface="Arial"/>
              <a:cs typeface="Arial"/>
            </a:endParaRPr>
          </a:p>
          <a:p>
            <a:pPr marL="301625" marR="5080">
              <a:lnSpc>
                <a:spcPct val="160000"/>
              </a:lnSpc>
              <a:spcBef>
                <a:spcPts val="85"/>
              </a:spcBef>
            </a:pPr>
            <a:r>
              <a:rPr sz="900" spc="-5" dirty="0">
                <a:latin typeface="Arial"/>
                <a:cs typeface="Arial"/>
              </a:rPr>
              <a:t>Ascomycota </a:t>
            </a:r>
            <a:r>
              <a:rPr sz="900" dirty="0">
                <a:latin typeface="Arial"/>
                <a:cs typeface="Arial"/>
              </a:rPr>
              <a:t> Basidio</a:t>
            </a:r>
            <a:r>
              <a:rPr sz="900" spc="-15" dirty="0">
                <a:latin typeface="Arial"/>
                <a:cs typeface="Arial"/>
              </a:rPr>
              <a:t>m</a:t>
            </a:r>
            <a:r>
              <a:rPr sz="900" dirty="0">
                <a:latin typeface="Arial"/>
                <a:cs typeface="Arial"/>
              </a:rPr>
              <a:t>ycota</a:t>
            </a:r>
            <a:endParaRPr sz="900">
              <a:latin typeface="Arial"/>
              <a:cs typeface="Arial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3682619" y="10286"/>
            <a:ext cx="2184781" cy="2128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300" dirty="0" err="1">
                <a:latin typeface="Arial"/>
                <a:cs typeface="Arial"/>
              </a:rPr>
              <a:t>Fungi_</a:t>
            </a:r>
            <a:r>
              <a:rPr sz="1300" dirty="0" err="1">
                <a:latin typeface="Arial"/>
                <a:cs typeface="Arial"/>
              </a:rPr>
              <a:t>Diseased_net</a:t>
            </a:r>
            <a:r>
              <a:rPr sz="1300" spc="-15" dirty="0" err="1">
                <a:latin typeface="Arial"/>
                <a:cs typeface="Arial"/>
              </a:rPr>
              <a:t>w</a:t>
            </a:r>
            <a:r>
              <a:rPr sz="1300" dirty="0" err="1">
                <a:latin typeface="Arial"/>
                <a:cs typeface="Arial"/>
              </a:rPr>
              <a:t>o</a:t>
            </a:r>
            <a:r>
              <a:rPr sz="1300" spc="15" dirty="0" err="1">
                <a:latin typeface="Arial"/>
                <a:cs typeface="Arial"/>
              </a:rPr>
              <a:t>r</a:t>
            </a:r>
            <a:r>
              <a:rPr sz="1300" dirty="0" err="1">
                <a:latin typeface="Arial"/>
                <a:cs typeface="Arial"/>
              </a:rPr>
              <a:t>k</a:t>
            </a:r>
            <a:endParaRPr sz="13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06717" y="623760"/>
            <a:ext cx="7689723" cy="7219696"/>
          </a:xfrm>
          <a:prstGeom prst="rect">
            <a:avLst/>
          </a:prstGeom>
        </p:spPr>
      </p:pic>
      <p:grpSp>
        <p:nvGrpSpPr>
          <p:cNvPr id="3" name="object 3"/>
          <p:cNvGrpSpPr/>
          <p:nvPr/>
        </p:nvGrpSpPr>
        <p:grpSpPr>
          <a:xfrm>
            <a:off x="8658225" y="1544066"/>
            <a:ext cx="219710" cy="3072765"/>
            <a:chOff x="8658225" y="1544066"/>
            <a:chExt cx="219710" cy="3072765"/>
          </a:xfrm>
        </p:grpSpPr>
        <p:sp>
          <p:nvSpPr>
            <p:cNvPr id="4" name="object 4"/>
            <p:cNvSpPr/>
            <p:nvPr/>
          </p:nvSpPr>
          <p:spPr>
            <a:xfrm>
              <a:off x="8658225" y="154406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8743188" y="1629029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5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5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F8766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8743188" y="1629029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5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5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8658225" y="176352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8743188" y="184848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E389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8743188" y="184848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8658225" y="1982978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8743188" y="206794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30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C49A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8743188" y="206794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30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8658225" y="220243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8743188" y="2287397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99A8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8743188" y="2287397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8658225" y="2421890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8743188" y="2506852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30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53B4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8743188" y="2506852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30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8658225" y="264134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8743188" y="2726308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00BC56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8743188" y="2726308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8658225" y="286080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8743188" y="294576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30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00C09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8743188" y="294576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30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8658225" y="3080258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8743188" y="316522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00BFC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8743188" y="316522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8" name="object 28"/>
            <p:cNvSpPr/>
            <p:nvPr/>
          </p:nvSpPr>
          <p:spPr>
            <a:xfrm>
              <a:off x="8658225" y="329971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9" name="object 29"/>
            <p:cNvSpPr/>
            <p:nvPr/>
          </p:nvSpPr>
          <p:spPr>
            <a:xfrm>
              <a:off x="8743188" y="338467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30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00B6EB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8743188" y="338467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30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8658225" y="3519170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8743188" y="3604133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06A4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8743188" y="3604133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8658225" y="373862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8743188" y="3823589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1"/>
                  </a:lnTo>
                  <a:lnTo>
                    <a:pt x="15162" y="47589"/>
                  </a:lnTo>
                  <a:lnTo>
                    <a:pt x="24764" y="49530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A58A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8743188" y="3823589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30"/>
                  </a:lnTo>
                  <a:lnTo>
                    <a:pt x="15162" y="47589"/>
                  </a:lnTo>
                  <a:lnTo>
                    <a:pt x="7286" y="42291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8658225" y="395808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8743188" y="404304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DF70F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9" name="object 39"/>
            <p:cNvSpPr/>
            <p:nvPr/>
          </p:nvSpPr>
          <p:spPr>
            <a:xfrm>
              <a:off x="8743188" y="4043045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0" name="object 40"/>
            <p:cNvSpPr/>
            <p:nvPr/>
          </p:nvSpPr>
          <p:spPr>
            <a:xfrm>
              <a:off x="8658225" y="4177538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8743188" y="426250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FB61D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2" name="object 42"/>
            <p:cNvSpPr/>
            <p:nvPr/>
          </p:nvSpPr>
          <p:spPr>
            <a:xfrm>
              <a:off x="8743188" y="426250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3" name="object 43"/>
            <p:cNvSpPr/>
            <p:nvPr/>
          </p:nvSpPr>
          <p:spPr>
            <a:xfrm>
              <a:off x="8658225" y="439699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4" name="object 44"/>
            <p:cNvSpPr/>
            <p:nvPr/>
          </p:nvSpPr>
          <p:spPr>
            <a:xfrm>
              <a:off x="8743188" y="4481957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764" y="0"/>
                  </a:moveTo>
                  <a:lnTo>
                    <a:pt x="15162" y="1958"/>
                  </a:lnTo>
                  <a:lnTo>
                    <a:pt x="7286" y="7286"/>
                  </a:lnTo>
                  <a:lnTo>
                    <a:pt x="1958" y="15162"/>
                  </a:lnTo>
                  <a:lnTo>
                    <a:pt x="0" y="24764"/>
                  </a:lnTo>
                  <a:lnTo>
                    <a:pt x="1958" y="34420"/>
                  </a:lnTo>
                  <a:lnTo>
                    <a:pt x="7286" y="42290"/>
                  </a:lnTo>
                  <a:lnTo>
                    <a:pt x="15162" y="47589"/>
                  </a:lnTo>
                  <a:lnTo>
                    <a:pt x="24764" y="49529"/>
                  </a:lnTo>
                  <a:lnTo>
                    <a:pt x="34440" y="47589"/>
                  </a:lnTo>
                  <a:lnTo>
                    <a:pt x="42354" y="42290"/>
                  </a:lnTo>
                  <a:lnTo>
                    <a:pt x="47696" y="34420"/>
                  </a:lnTo>
                  <a:lnTo>
                    <a:pt x="49656" y="24764"/>
                  </a:lnTo>
                  <a:lnTo>
                    <a:pt x="47696" y="15162"/>
                  </a:lnTo>
                  <a:lnTo>
                    <a:pt x="42354" y="7286"/>
                  </a:lnTo>
                  <a:lnTo>
                    <a:pt x="34440" y="1958"/>
                  </a:lnTo>
                  <a:lnTo>
                    <a:pt x="24764" y="0"/>
                  </a:lnTo>
                  <a:close/>
                </a:path>
              </a:pathLst>
            </a:custGeom>
            <a:solidFill>
              <a:srgbClr val="FF66A8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5" name="object 45"/>
            <p:cNvSpPr/>
            <p:nvPr/>
          </p:nvSpPr>
          <p:spPr>
            <a:xfrm>
              <a:off x="8743188" y="4481957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58" y="15162"/>
                  </a:lnTo>
                  <a:lnTo>
                    <a:pt x="7286" y="7286"/>
                  </a:lnTo>
                  <a:lnTo>
                    <a:pt x="15162" y="1958"/>
                  </a:lnTo>
                  <a:lnTo>
                    <a:pt x="24764" y="0"/>
                  </a:lnTo>
                  <a:lnTo>
                    <a:pt x="34440" y="1958"/>
                  </a:lnTo>
                  <a:lnTo>
                    <a:pt x="42354" y="7286"/>
                  </a:lnTo>
                  <a:lnTo>
                    <a:pt x="47696" y="15162"/>
                  </a:lnTo>
                  <a:lnTo>
                    <a:pt x="49656" y="24764"/>
                  </a:lnTo>
                  <a:lnTo>
                    <a:pt x="47696" y="34420"/>
                  </a:lnTo>
                  <a:lnTo>
                    <a:pt x="42354" y="42290"/>
                  </a:lnTo>
                  <a:lnTo>
                    <a:pt x="34440" y="47589"/>
                  </a:lnTo>
                  <a:lnTo>
                    <a:pt x="24764" y="49529"/>
                  </a:lnTo>
                  <a:lnTo>
                    <a:pt x="15162" y="47589"/>
                  </a:lnTo>
                  <a:lnTo>
                    <a:pt x="7286" y="42290"/>
                  </a:lnTo>
                  <a:lnTo>
                    <a:pt x="1958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6" name="object 46"/>
          <p:cNvGrpSpPr/>
          <p:nvPr/>
        </p:nvGrpSpPr>
        <p:grpSpPr>
          <a:xfrm>
            <a:off x="8658225" y="5095494"/>
            <a:ext cx="219710" cy="219710"/>
            <a:chOff x="8658225" y="5095494"/>
            <a:chExt cx="219710" cy="219710"/>
          </a:xfrm>
        </p:grpSpPr>
        <p:sp>
          <p:nvSpPr>
            <p:cNvPr id="47" name="object 47"/>
            <p:cNvSpPr/>
            <p:nvPr/>
          </p:nvSpPr>
          <p:spPr>
            <a:xfrm>
              <a:off x="8658225" y="509549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8" name="object 48"/>
            <p:cNvSpPr/>
            <p:nvPr/>
          </p:nvSpPr>
          <p:spPr>
            <a:xfrm>
              <a:off x="8680196" y="5205222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>
                  <a:moveTo>
                    <a:pt x="0" y="0"/>
                  </a:moveTo>
                  <a:lnTo>
                    <a:pt x="175640" y="0"/>
                  </a:lnTo>
                </a:path>
              </a:pathLst>
            </a:custGeom>
            <a:ln w="3175">
              <a:solidFill>
                <a:srgbClr val="6D98B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49" name="object 49"/>
          <p:cNvGrpSpPr/>
          <p:nvPr/>
        </p:nvGrpSpPr>
        <p:grpSpPr>
          <a:xfrm>
            <a:off x="8658225" y="5793866"/>
            <a:ext cx="219710" cy="1316990"/>
            <a:chOff x="8658225" y="5793866"/>
            <a:chExt cx="219710" cy="1316990"/>
          </a:xfrm>
        </p:grpSpPr>
        <p:sp>
          <p:nvSpPr>
            <p:cNvPr id="50" name="object 50"/>
            <p:cNvSpPr/>
            <p:nvPr/>
          </p:nvSpPr>
          <p:spPr>
            <a:xfrm>
              <a:off x="8658225" y="579386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1" name="object 51"/>
            <p:cNvSpPr/>
            <p:nvPr/>
          </p:nvSpPr>
          <p:spPr>
            <a:xfrm>
              <a:off x="8752713" y="5888227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5" h="31114">
                  <a:moveTo>
                    <a:pt x="0" y="15367"/>
                  </a:moveTo>
                  <a:lnTo>
                    <a:pt x="0" y="6985"/>
                  </a:lnTo>
                  <a:lnTo>
                    <a:pt x="6857" y="0"/>
                  </a:lnTo>
                  <a:lnTo>
                    <a:pt x="15239" y="0"/>
                  </a:lnTo>
                  <a:lnTo>
                    <a:pt x="23748" y="0"/>
                  </a:lnTo>
                  <a:lnTo>
                    <a:pt x="30606" y="6985"/>
                  </a:lnTo>
                  <a:lnTo>
                    <a:pt x="30606" y="15367"/>
                  </a:lnTo>
                  <a:lnTo>
                    <a:pt x="30606" y="23876"/>
                  </a:lnTo>
                  <a:lnTo>
                    <a:pt x="23748" y="30734"/>
                  </a:lnTo>
                  <a:lnTo>
                    <a:pt x="15239" y="30734"/>
                  </a:lnTo>
                  <a:lnTo>
                    <a:pt x="6857" y="30734"/>
                  </a:lnTo>
                  <a:lnTo>
                    <a:pt x="0" y="23876"/>
                  </a:lnTo>
                  <a:lnTo>
                    <a:pt x="0" y="1536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2" name="object 52"/>
            <p:cNvSpPr/>
            <p:nvPr/>
          </p:nvSpPr>
          <p:spPr>
            <a:xfrm>
              <a:off x="8658225" y="6013322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3" name="object 53"/>
            <p:cNvSpPr/>
            <p:nvPr/>
          </p:nvSpPr>
          <p:spPr>
            <a:xfrm>
              <a:off x="8727439" y="6082537"/>
              <a:ext cx="81280" cy="81280"/>
            </a:xfrm>
            <a:custGeom>
              <a:avLst/>
              <a:gdLst/>
              <a:ahLst/>
              <a:cxnLst/>
              <a:rect l="l" t="t" r="r" b="b"/>
              <a:pathLst>
                <a:path w="81279" h="81279">
                  <a:moveTo>
                    <a:pt x="0" y="40512"/>
                  </a:moveTo>
                  <a:lnTo>
                    <a:pt x="3204" y="24753"/>
                  </a:lnTo>
                  <a:lnTo>
                    <a:pt x="11922" y="11874"/>
                  </a:lnTo>
                  <a:lnTo>
                    <a:pt x="24806" y="3186"/>
                  </a:lnTo>
                  <a:lnTo>
                    <a:pt x="40512" y="0"/>
                  </a:lnTo>
                  <a:lnTo>
                    <a:pt x="56292" y="3186"/>
                  </a:lnTo>
                  <a:lnTo>
                    <a:pt x="69214" y="11874"/>
                  </a:lnTo>
                  <a:lnTo>
                    <a:pt x="77946" y="24753"/>
                  </a:lnTo>
                  <a:lnTo>
                    <a:pt x="81152" y="40512"/>
                  </a:lnTo>
                  <a:lnTo>
                    <a:pt x="77946" y="56272"/>
                  </a:lnTo>
                  <a:lnTo>
                    <a:pt x="69214" y="69151"/>
                  </a:lnTo>
                  <a:lnTo>
                    <a:pt x="56292" y="77839"/>
                  </a:lnTo>
                  <a:lnTo>
                    <a:pt x="40512" y="81025"/>
                  </a:lnTo>
                  <a:lnTo>
                    <a:pt x="24806" y="77839"/>
                  </a:lnTo>
                  <a:lnTo>
                    <a:pt x="11922" y="69151"/>
                  </a:lnTo>
                  <a:lnTo>
                    <a:pt x="3204" y="56272"/>
                  </a:lnTo>
                  <a:lnTo>
                    <a:pt x="0" y="40512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4" name="object 54"/>
            <p:cNvSpPr/>
            <p:nvPr/>
          </p:nvSpPr>
          <p:spPr>
            <a:xfrm>
              <a:off x="8658225" y="6232778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5" name="object 55"/>
            <p:cNvSpPr/>
            <p:nvPr/>
          </p:nvSpPr>
          <p:spPr>
            <a:xfrm>
              <a:off x="8717026" y="6291579"/>
              <a:ext cx="102235" cy="102235"/>
            </a:xfrm>
            <a:custGeom>
              <a:avLst/>
              <a:gdLst/>
              <a:ahLst/>
              <a:cxnLst/>
              <a:rect l="l" t="t" r="r" b="b"/>
              <a:pathLst>
                <a:path w="102234" h="102235">
                  <a:moveTo>
                    <a:pt x="0" y="50927"/>
                  </a:moveTo>
                  <a:lnTo>
                    <a:pt x="4028" y="31128"/>
                  </a:lnTo>
                  <a:lnTo>
                    <a:pt x="14986" y="14938"/>
                  </a:lnTo>
                  <a:lnTo>
                    <a:pt x="31182" y="4010"/>
                  </a:lnTo>
                  <a:lnTo>
                    <a:pt x="50926" y="0"/>
                  </a:lnTo>
                  <a:lnTo>
                    <a:pt x="70744" y="4010"/>
                  </a:lnTo>
                  <a:lnTo>
                    <a:pt x="86979" y="14938"/>
                  </a:lnTo>
                  <a:lnTo>
                    <a:pt x="97950" y="31128"/>
                  </a:lnTo>
                  <a:lnTo>
                    <a:pt x="101980" y="50927"/>
                  </a:lnTo>
                  <a:lnTo>
                    <a:pt x="97950" y="70725"/>
                  </a:lnTo>
                  <a:lnTo>
                    <a:pt x="86979" y="86915"/>
                  </a:lnTo>
                  <a:lnTo>
                    <a:pt x="70744" y="97843"/>
                  </a:lnTo>
                  <a:lnTo>
                    <a:pt x="50926" y="101854"/>
                  </a:lnTo>
                  <a:lnTo>
                    <a:pt x="31182" y="97843"/>
                  </a:lnTo>
                  <a:lnTo>
                    <a:pt x="14985" y="86915"/>
                  </a:lnTo>
                  <a:lnTo>
                    <a:pt x="4028" y="70725"/>
                  </a:lnTo>
                  <a:lnTo>
                    <a:pt x="0" y="50927"/>
                  </a:lnTo>
                </a:path>
              </a:pathLst>
            </a:custGeom>
            <a:ln w="9016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6" name="object 56"/>
            <p:cNvSpPr/>
            <p:nvPr/>
          </p:nvSpPr>
          <p:spPr>
            <a:xfrm>
              <a:off x="8658225" y="6452234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09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7" name="object 57"/>
            <p:cNvSpPr/>
            <p:nvPr/>
          </p:nvSpPr>
          <p:spPr>
            <a:xfrm>
              <a:off x="8709025" y="6503034"/>
              <a:ext cx="118110" cy="118110"/>
            </a:xfrm>
            <a:custGeom>
              <a:avLst/>
              <a:gdLst/>
              <a:ahLst/>
              <a:cxnLst/>
              <a:rect l="l" t="t" r="r" b="b"/>
              <a:pathLst>
                <a:path w="118109" h="118109">
                  <a:moveTo>
                    <a:pt x="0" y="58928"/>
                  </a:moveTo>
                  <a:lnTo>
                    <a:pt x="4653" y="36058"/>
                  </a:lnTo>
                  <a:lnTo>
                    <a:pt x="17319" y="17319"/>
                  </a:lnTo>
                  <a:lnTo>
                    <a:pt x="36058" y="4653"/>
                  </a:lnTo>
                  <a:lnTo>
                    <a:pt x="58927" y="0"/>
                  </a:lnTo>
                  <a:lnTo>
                    <a:pt x="81871" y="4653"/>
                  </a:lnTo>
                  <a:lnTo>
                    <a:pt x="100647" y="17319"/>
                  </a:lnTo>
                  <a:lnTo>
                    <a:pt x="113327" y="36058"/>
                  </a:lnTo>
                  <a:lnTo>
                    <a:pt x="117982" y="58928"/>
                  </a:lnTo>
                  <a:lnTo>
                    <a:pt x="113327" y="81871"/>
                  </a:lnTo>
                  <a:lnTo>
                    <a:pt x="100647" y="100647"/>
                  </a:lnTo>
                  <a:lnTo>
                    <a:pt x="81871" y="113327"/>
                  </a:lnTo>
                  <a:lnTo>
                    <a:pt x="58927" y="117983"/>
                  </a:lnTo>
                  <a:lnTo>
                    <a:pt x="36058" y="113327"/>
                  </a:lnTo>
                  <a:lnTo>
                    <a:pt x="17319" y="100647"/>
                  </a:lnTo>
                  <a:lnTo>
                    <a:pt x="4653" y="81871"/>
                  </a:lnTo>
                  <a:lnTo>
                    <a:pt x="0" y="58928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8" name="object 58"/>
            <p:cNvSpPr/>
            <p:nvPr/>
          </p:nvSpPr>
          <p:spPr>
            <a:xfrm>
              <a:off x="8658225" y="6671690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09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9" name="object 59"/>
            <p:cNvSpPr/>
            <p:nvPr/>
          </p:nvSpPr>
          <p:spPr>
            <a:xfrm>
              <a:off x="8702294" y="6715632"/>
              <a:ext cx="131445" cy="132080"/>
            </a:xfrm>
            <a:custGeom>
              <a:avLst/>
              <a:gdLst/>
              <a:ahLst/>
              <a:cxnLst/>
              <a:rect l="l" t="t" r="r" b="b"/>
              <a:pathLst>
                <a:path w="131445" h="132079">
                  <a:moveTo>
                    <a:pt x="0" y="65786"/>
                  </a:moveTo>
                  <a:lnTo>
                    <a:pt x="5187" y="40237"/>
                  </a:lnTo>
                  <a:lnTo>
                    <a:pt x="19303" y="19319"/>
                  </a:lnTo>
                  <a:lnTo>
                    <a:pt x="40183" y="5189"/>
                  </a:lnTo>
                  <a:lnTo>
                    <a:pt x="65658" y="0"/>
                  </a:lnTo>
                  <a:lnTo>
                    <a:pt x="91207" y="5189"/>
                  </a:lnTo>
                  <a:lnTo>
                    <a:pt x="112125" y="19319"/>
                  </a:lnTo>
                  <a:lnTo>
                    <a:pt x="126255" y="40237"/>
                  </a:lnTo>
                  <a:lnTo>
                    <a:pt x="131445" y="65786"/>
                  </a:lnTo>
                  <a:lnTo>
                    <a:pt x="126255" y="91334"/>
                  </a:lnTo>
                  <a:lnTo>
                    <a:pt x="112125" y="112252"/>
                  </a:lnTo>
                  <a:lnTo>
                    <a:pt x="91207" y="126382"/>
                  </a:lnTo>
                  <a:lnTo>
                    <a:pt x="65658" y="131572"/>
                  </a:lnTo>
                  <a:lnTo>
                    <a:pt x="40183" y="126382"/>
                  </a:lnTo>
                  <a:lnTo>
                    <a:pt x="19303" y="112252"/>
                  </a:lnTo>
                  <a:lnTo>
                    <a:pt x="5187" y="91334"/>
                  </a:lnTo>
                  <a:lnTo>
                    <a:pt x="0" y="65786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0" name="object 60"/>
            <p:cNvSpPr/>
            <p:nvPr/>
          </p:nvSpPr>
          <p:spPr>
            <a:xfrm>
              <a:off x="8658225" y="689114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09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1" name="object 61"/>
            <p:cNvSpPr/>
            <p:nvPr/>
          </p:nvSpPr>
          <p:spPr>
            <a:xfrm>
              <a:off x="8696325" y="6929246"/>
              <a:ext cx="143510" cy="143510"/>
            </a:xfrm>
            <a:custGeom>
              <a:avLst/>
              <a:gdLst/>
              <a:ahLst/>
              <a:cxnLst/>
              <a:rect l="l" t="t" r="r" b="b"/>
              <a:pathLst>
                <a:path w="143509" h="143509">
                  <a:moveTo>
                    <a:pt x="0" y="71627"/>
                  </a:moveTo>
                  <a:lnTo>
                    <a:pt x="5655" y="43826"/>
                  </a:lnTo>
                  <a:lnTo>
                    <a:pt x="21050" y="21050"/>
                  </a:lnTo>
                  <a:lnTo>
                    <a:pt x="43826" y="5655"/>
                  </a:lnTo>
                  <a:lnTo>
                    <a:pt x="71627" y="0"/>
                  </a:lnTo>
                  <a:lnTo>
                    <a:pt x="99502" y="5655"/>
                  </a:lnTo>
                  <a:lnTo>
                    <a:pt x="122316" y="21050"/>
                  </a:lnTo>
                  <a:lnTo>
                    <a:pt x="137725" y="43826"/>
                  </a:lnTo>
                  <a:lnTo>
                    <a:pt x="143382" y="71627"/>
                  </a:lnTo>
                  <a:lnTo>
                    <a:pt x="137725" y="99502"/>
                  </a:lnTo>
                  <a:lnTo>
                    <a:pt x="122316" y="122316"/>
                  </a:lnTo>
                  <a:lnTo>
                    <a:pt x="99502" y="137725"/>
                  </a:lnTo>
                  <a:lnTo>
                    <a:pt x="71627" y="143382"/>
                  </a:lnTo>
                  <a:lnTo>
                    <a:pt x="43826" y="137725"/>
                  </a:lnTo>
                  <a:lnTo>
                    <a:pt x="21050" y="122316"/>
                  </a:lnTo>
                  <a:lnTo>
                    <a:pt x="5655" y="99502"/>
                  </a:lnTo>
                  <a:lnTo>
                    <a:pt x="0" y="7162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62" name="object 62"/>
          <p:cNvSpPr txBox="1"/>
          <p:nvPr/>
        </p:nvSpPr>
        <p:spPr>
          <a:xfrm>
            <a:off x="8645525" y="1306703"/>
            <a:ext cx="1286510" cy="57708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10" dirty="0">
                <a:latin typeface="Arial"/>
                <a:cs typeface="Arial"/>
              </a:rPr>
              <a:t>Phylum</a:t>
            </a:r>
            <a:endParaRPr sz="1100">
              <a:latin typeface="Arial"/>
              <a:cs typeface="Arial"/>
            </a:endParaRPr>
          </a:p>
          <a:p>
            <a:pPr marL="301625" marR="5080">
              <a:lnSpc>
                <a:spcPct val="160000"/>
              </a:lnSpc>
              <a:spcBef>
                <a:spcPts val="85"/>
              </a:spcBef>
            </a:pPr>
            <a:r>
              <a:rPr sz="900" dirty="0">
                <a:latin typeface="Arial"/>
                <a:cs typeface="Arial"/>
              </a:rPr>
              <a:t>Abditibacteri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Acidobacteri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Actinobacteri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Armatimonad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Bacteroid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Bdellovibrionota </a:t>
            </a:r>
            <a:r>
              <a:rPr sz="900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Chloroflexi </a:t>
            </a:r>
            <a:r>
              <a:rPr sz="900" dirty="0">
                <a:latin typeface="Arial"/>
                <a:cs typeface="Arial"/>
              </a:rPr>
              <a:t> Deinococc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Firmicutes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Gemmatimonadota  Myxococc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Planctomycetota </a:t>
            </a:r>
            <a:r>
              <a:rPr sz="900" dirty="0">
                <a:latin typeface="Arial"/>
                <a:cs typeface="Arial"/>
              </a:rPr>
              <a:t> Proteobacteri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Verrucomicrobiota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100" dirty="0">
                <a:latin typeface="Arial"/>
                <a:cs typeface="Arial"/>
              </a:rPr>
              <a:t>cor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+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100" spc="-5" dirty="0">
                <a:latin typeface="Arial"/>
                <a:cs typeface="Arial"/>
              </a:rPr>
              <a:t>igraph.degree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1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3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4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50</a:t>
            </a:r>
            <a:endParaRPr sz="900">
              <a:latin typeface="Arial"/>
              <a:cs typeface="Arial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3567429" y="10286"/>
            <a:ext cx="2299971" cy="2128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300" dirty="0" err="1">
                <a:latin typeface="Arial"/>
                <a:cs typeface="Arial"/>
              </a:rPr>
              <a:t>Bacteria_</a:t>
            </a:r>
            <a:r>
              <a:rPr sz="1300" dirty="0" err="1">
                <a:latin typeface="Arial"/>
                <a:cs typeface="Arial"/>
              </a:rPr>
              <a:t>Diseased_net</a:t>
            </a:r>
            <a:r>
              <a:rPr sz="1300" spc="-15" dirty="0" err="1">
                <a:latin typeface="Arial"/>
                <a:cs typeface="Arial"/>
              </a:rPr>
              <a:t>w</a:t>
            </a:r>
            <a:r>
              <a:rPr sz="1300" dirty="0" err="1">
                <a:latin typeface="Arial"/>
                <a:cs typeface="Arial"/>
              </a:rPr>
              <a:t>o</a:t>
            </a:r>
            <a:r>
              <a:rPr sz="1300" spc="15" dirty="0" err="1">
                <a:latin typeface="Arial"/>
                <a:cs typeface="Arial"/>
              </a:rPr>
              <a:t>r</a:t>
            </a:r>
            <a:r>
              <a:rPr sz="1300" dirty="0" err="1">
                <a:latin typeface="Arial"/>
                <a:cs typeface="Arial"/>
              </a:rPr>
              <a:t>k</a:t>
            </a:r>
            <a:endParaRPr sz="1300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object 2"/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402653" y="622744"/>
            <a:ext cx="7846440" cy="7208520"/>
          </a:xfrm>
          <a:prstGeom prst="rect">
            <a:avLst/>
          </a:prstGeom>
        </p:spPr>
      </p:pic>
      <p:grpSp>
        <p:nvGrpSpPr>
          <p:cNvPr id="3" name="object 3"/>
          <p:cNvGrpSpPr/>
          <p:nvPr/>
        </p:nvGrpSpPr>
        <p:grpSpPr>
          <a:xfrm>
            <a:off x="8808973" y="2312161"/>
            <a:ext cx="219710" cy="1755775"/>
            <a:chOff x="8808973" y="2312161"/>
            <a:chExt cx="219710" cy="1755775"/>
          </a:xfrm>
        </p:grpSpPr>
        <p:sp>
          <p:nvSpPr>
            <p:cNvPr id="4" name="object 4"/>
            <p:cNvSpPr/>
            <p:nvPr/>
          </p:nvSpPr>
          <p:spPr>
            <a:xfrm>
              <a:off x="8808973" y="231216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5" name="object 5"/>
            <p:cNvSpPr/>
            <p:nvPr/>
          </p:nvSpPr>
          <p:spPr>
            <a:xfrm>
              <a:off x="8893809" y="2397124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4"/>
                  </a:lnTo>
                  <a:lnTo>
                    <a:pt x="1960" y="34420"/>
                  </a:lnTo>
                  <a:lnTo>
                    <a:pt x="7302" y="42290"/>
                  </a:lnTo>
                  <a:lnTo>
                    <a:pt x="15216" y="47589"/>
                  </a:lnTo>
                  <a:lnTo>
                    <a:pt x="24892" y="49529"/>
                  </a:lnTo>
                  <a:lnTo>
                    <a:pt x="34494" y="47589"/>
                  </a:lnTo>
                  <a:lnTo>
                    <a:pt x="42370" y="42290"/>
                  </a:lnTo>
                  <a:lnTo>
                    <a:pt x="47698" y="34420"/>
                  </a:lnTo>
                  <a:lnTo>
                    <a:pt x="49657" y="24764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F8766D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6" name="object 6"/>
            <p:cNvSpPr/>
            <p:nvPr/>
          </p:nvSpPr>
          <p:spPr>
            <a:xfrm>
              <a:off x="8893809" y="2397124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4"/>
                  </a:lnTo>
                  <a:lnTo>
                    <a:pt x="47698" y="34420"/>
                  </a:lnTo>
                  <a:lnTo>
                    <a:pt x="42370" y="42290"/>
                  </a:lnTo>
                  <a:lnTo>
                    <a:pt x="34494" y="47589"/>
                  </a:lnTo>
                  <a:lnTo>
                    <a:pt x="24892" y="49529"/>
                  </a:lnTo>
                  <a:lnTo>
                    <a:pt x="15216" y="47589"/>
                  </a:lnTo>
                  <a:lnTo>
                    <a:pt x="7302" y="42290"/>
                  </a:lnTo>
                  <a:lnTo>
                    <a:pt x="1960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8808973" y="2531617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8893809" y="2616580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5"/>
                  </a:lnTo>
                  <a:lnTo>
                    <a:pt x="1960" y="34420"/>
                  </a:lnTo>
                  <a:lnTo>
                    <a:pt x="7302" y="42291"/>
                  </a:lnTo>
                  <a:lnTo>
                    <a:pt x="15216" y="47589"/>
                  </a:lnTo>
                  <a:lnTo>
                    <a:pt x="24892" y="49530"/>
                  </a:lnTo>
                  <a:lnTo>
                    <a:pt x="34494" y="47589"/>
                  </a:lnTo>
                  <a:lnTo>
                    <a:pt x="42370" y="42291"/>
                  </a:lnTo>
                  <a:lnTo>
                    <a:pt x="47698" y="34420"/>
                  </a:lnTo>
                  <a:lnTo>
                    <a:pt x="49657" y="24765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CD96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8893809" y="2616580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5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5"/>
                  </a:lnTo>
                  <a:lnTo>
                    <a:pt x="47698" y="34420"/>
                  </a:lnTo>
                  <a:lnTo>
                    <a:pt x="42370" y="42291"/>
                  </a:lnTo>
                  <a:lnTo>
                    <a:pt x="34494" y="47589"/>
                  </a:lnTo>
                  <a:lnTo>
                    <a:pt x="24892" y="49530"/>
                  </a:lnTo>
                  <a:lnTo>
                    <a:pt x="15216" y="47589"/>
                  </a:lnTo>
                  <a:lnTo>
                    <a:pt x="7302" y="42291"/>
                  </a:lnTo>
                  <a:lnTo>
                    <a:pt x="1960" y="34420"/>
                  </a:lnTo>
                  <a:lnTo>
                    <a:pt x="0" y="2476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8808973" y="2751073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8893809" y="283603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4"/>
                  </a:lnTo>
                  <a:lnTo>
                    <a:pt x="1960" y="34420"/>
                  </a:lnTo>
                  <a:lnTo>
                    <a:pt x="7302" y="42290"/>
                  </a:lnTo>
                  <a:lnTo>
                    <a:pt x="15216" y="47589"/>
                  </a:lnTo>
                  <a:lnTo>
                    <a:pt x="24892" y="49529"/>
                  </a:lnTo>
                  <a:lnTo>
                    <a:pt x="34494" y="47589"/>
                  </a:lnTo>
                  <a:lnTo>
                    <a:pt x="42370" y="42290"/>
                  </a:lnTo>
                  <a:lnTo>
                    <a:pt x="47698" y="34420"/>
                  </a:lnTo>
                  <a:lnTo>
                    <a:pt x="49657" y="24764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7CAE00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8893809" y="283603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4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4"/>
                  </a:lnTo>
                  <a:lnTo>
                    <a:pt x="47698" y="34420"/>
                  </a:lnTo>
                  <a:lnTo>
                    <a:pt x="42370" y="42290"/>
                  </a:lnTo>
                  <a:lnTo>
                    <a:pt x="34494" y="47589"/>
                  </a:lnTo>
                  <a:lnTo>
                    <a:pt x="24892" y="49529"/>
                  </a:lnTo>
                  <a:lnTo>
                    <a:pt x="15216" y="47589"/>
                  </a:lnTo>
                  <a:lnTo>
                    <a:pt x="7302" y="42290"/>
                  </a:lnTo>
                  <a:lnTo>
                    <a:pt x="1960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3" name="object 13"/>
            <p:cNvSpPr/>
            <p:nvPr/>
          </p:nvSpPr>
          <p:spPr>
            <a:xfrm>
              <a:off x="8808973" y="2970529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4" name="object 14"/>
            <p:cNvSpPr/>
            <p:nvPr/>
          </p:nvSpPr>
          <p:spPr>
            <a:xfrm>
              <a:off x="8893809" y="3055492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5"/>
                  </a:lnTo>
                  <a:lnTo>
                    <a:pt x="1960" y="34420"/>
                  </a:lnTo>
                  <a:lnTo>
                    <a:pt x="7302" y="42291"/>
                  </a:lnTo>
                  <a:lnTo>
                    <a:pt x="15216" y="47589"/>
                  </a:lnTo>
                  <a:lnTo>
                    <a:pt x="24892" y="49530"/>
                  </a:lnTo>
                  <a:lnTo>
                    <a:pt x="34494" y="47589"/>
                  </a:lnTo>
                  <a:lnTo>
                    <a:pt x="42370" y="42291"/>
                  </a:lnTo>
                  <a:lnTo>
                    <a:pt x="47698" y="34420"/>
                  </a:lnTo>
                  <a:lnTo>
                    <a:pt x="49657" y="24765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00BE67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5" name="object 15"/>
            <p:cNvSpPr/>
            <p:nvPr/>
          </p:nvSpPr>
          <p:spPr>
            <a:xfrm>
              <a:off x="8893809" y="3055492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30">
                  <a:moveTo>
                    <a:pt x="0" y="24765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5"/>
                  </a:lnTo>
                  <a:lnTo>
                    <a:pt x="47698" y="34420"/>
                  </a:lnTo>
                  <a:lnTo>
                    <a:pt x="42370" y="42291"/>
                  </a:lnTo>
                  <a:lnTo>
                    <a:pt x="34494" y="47589"/>
                  </a:lnTo>
                  <a:lnTo>
                    <a:pt x="24892" y="49530"/>
                  </a:lnTo>
                  <a:lnTo>
                    <a:pt x="15216" y="47589"/>
                  </a:lnTo>
                  <a:lnTo>
                    <a:pt x="7302" y="42291"/>
                  </a:lnTo>
                  <a:lnTo>
                    <a:pt x="1960" y="34420"/>
                  </a:lnTo>
                  <a:lnTo>
                    <a:pt x="0" y="2476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6" name="object 16"/>
            <p:cNvSpPr/>
            <p:nvPr/>
          </p:nvSpPr>
          <p:spPr>
            <a:xfrm>
              <a:off x="8808973" y="3189986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7" name="object 17"/>
            <p:cNvSpPr/>
            <p:nvPr/>
          </p:nvSpPr>
          <p:spPr>
            <a:xfrm>
              <a:off x="8893809" y="3274948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4"/>
                  </a:lnTo>
                  <a:lnTo>
                    <a:pt x="1960" y="34420"/>
                  </a:lnTo>
                  <a:lnTo>
                    <a:pt x="7302" y="42290"/>
                  </a:lnTo>
                  <a:lnTo>
                    <a:pt x="15216" y="47589"/>
                  </a:lnTo>
                  <a:lnTo>
                    <a:pt x="24892" y="49529"/>
                  </a:lnTo>
                  <a:lnTo>
                    <a:pt x="34494" y="47589"/>
                  </a:lnTo>
                  <a:lnTo>
                    <a:pt x="42370" y="42290"/>
                  </a:lnTo>
                  <a:lnTo>
                    <a:pt x="47698" y="34420"/>
                  </a:lnTo>
                  <a:lnTo>
                    <a:pt x="49657" y="24764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00BFC4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8" name="object 18"/>
            <p:cNvSpPr/>
            <p:nvPr/>
          </p:nvSpPr>
          <p:spPr>
            <a:xfrm>
              <a:off x="8893809" y="3274948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4"/>
                  </a:lnTo>
                  <a:lnTo>
                    <a:pt x="47698" y="34420"/>
                  </a:lnTo>
                  <a:lnTo>
                    <a:pt x="42370" y="42290"/>
                  </a:lnTo>
                  <a:lnTo>
                    <a:pt x="34494" y="47589"/>
                  </a:lnTo>
                  <a:lnTo>
                    <a:pt x="24892" y="49529"/>
                  </a:lnTo>
                  <a:lnTo>
                    <a:pt x="15216" y="47589"/>
                  </a:lnTo>
                  <a:lnTo>
                    <a:pt x="7302" y="42290"/>
                  </a:lnTo>
                  <a:lnTo>
                    <a:pt x="1960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9" name="object 19"/>
            <p:cNvSpPr/>
            <p:nvPr/>
          </p:nvSpPr>
          <p:spPr>
            <a:xfrm>
              <a:off x="8808973" y="340944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0" name="object 20"/>
            <p:cNvSpPr/>
            <p:nvPr/>
          </p:nvSpPr>
          <p:spPr>
            <a:xfrm>
              <a:off x="8893809" y="3494404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5"/>
                  </a:lnTo>
                  <a:lnTo>
                    <a:pt x="1960" y="34420"/>
                  </a:lnTo>
                  <a:lnTo>
                    <a:pt x="7302" y="42291"/>
                  </a:lnTo>
                  <a:lnTo>
                    <a:pt x="15216" y="47589"/>
                  </a:lnTo>
                  <a:lnTo>
                    <a:pt x="24892" y="49530"/>
                  </a:lnTo>
                  <a:lnTo>
                    <a:pt x="34494" y="47589"/>
                  </a:lnTo>
                  <a:lnTo>
                    <a:pt x="42370" y="42291"/>
                  </a:lnTo>
                  <a:lnTo>
                    <a:pt x="47698" y="34420"/>
                  </a:lnTo>
                  <a:lnTo>
                    <a:pt x="49657" y="24765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00A9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1" name="object 21"/>
            <p:cNvSpPr/>
            <p:nvPr/>
          </p:nvSpPr>
          <p:spPr>
            <a:xfrm>
              <a:off x="8893809" y="3494404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5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5"/>
                  </a:lnTo>
                  <a:lnTo>
                    <a:pt x="47698" y="34420"/>
                  </a:lnTo>
                  <a:lnTo>
                    <a:pt x="42370" y="42291"/>
                  </a:lnTo>
                  <a:lnTo>
                    <a:pt x="34494" y="47589"/>
                  </a:lnTo>
                  <a:lnTo>
                    <a:pt x="24892" y="49530"/>
                  </a:lnTo>
                  <a:lnTo>
                    <a:pt x="15216" y="47589"/>
                  </a:lnTo>
                  <a:lnTo>
                    <a:pt x="7302" y="42291"/>
                  </a:lnTo>
                  <a:lnTo>
                    <a:pt x="1960" y="34420"/>
                  </a:lnTo>
                  <a:lnTo>
                    <a:pt x="0" y="2476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2" name="object 22"/>
            <p:cNvSpPr/>
            <p:nvPr/>
          </p:nvSpPr>
          <p:spPr>
            <a:xfrm>
              <a:off x="8808973" y="3628897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3" name="object 23"/>
            <p:cNvSpPr/>
            <p:nvPr/>
          </p:nvSpPr>
          <p:spPr>
            <a:xfrm>
              <a:off x="8893809" y="371386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4"/>
                  </a:lnTo>
                  <a:lnTo>
                    <a:pt x="1960" y="34420"/>
                  </a:lnTo>
                  <a:lnTo>
                    <a:pt x="7302" y="42290"/>
                  </a:lnTo>
                  <a:lnTo>
                    <a:pt x="15216" y="47589"/>
                  </a:lnTo>
                  <a:lnTo>
                    <a:pt x="24892" y="49529"/>
                  </a:lnTo>
                  <a:lnTo>
                    <a:pt x="34494" y="47589"/>
                  </a:lnTo>
                  <a:lnTo>
                    <a:pt x="42370" y="42290"/>
                  </a:lnTo>
                  <a:lnTo>
                    <a:pt x="47698" y="34420"/>
                  </a:lnTo>
                  <a:lnTo>
                    <a:pt x="49657" y="24764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C77CFF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4" name="object 24"/>
            <p:cNvSpPr/>
            <p:nvPr/>
          </p:nvSpPr>
          <p:spPr>
            <a:xfrm>
              <a:off x="8893809" y="3713861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4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4"/>
                  </a:lnTo>
                  <a:lnTo>
                    <a:pt x="47698" y="34420"/>
                  </a:lnTo>
                  <a:lnTo>
                    <a:pt x="42370" y="42290"/>
                  </a:lnTo>
                  <a:lnTo>
                    <a:pt x="34494" y="47589"/>
                  </a:lnTo>
                  <a:lnTo>
                    <a:pt x="24892" y="49529"/>
                  </a:lnTo>
                  <a:lnTo>
                    <a:pt x="15216" y="47589"/>
                  </a:lnTo>
                  <a:lnTo>
                    <a:pt x="7302" y="42290"/>
                  </a:lnTo>
                  <a:lnTo>
                    <a:pt x="1960" y="34420"/>
                  </a:lnTo>
                  <a:lnTo>
                    <a:pt x="0" y="2476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5" name="object 25"/>
            <p:cNvSpPr/>
            <p:nvPr/>
          </p:nvSpPr>
          <p:spPr>
            <a:xfrm>
              <a:off x="8808973" y="3848353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6" name="object 26"/>
            <p:cNvSpPr/>
            <p:nvPr/>
          </p:nvSpPr>
          <p:spPr>
            <a:xfrm>
              <a:off x="8893809" y="393331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24892" y="0"/>
                  </a:moveTo>
                  <a:lnTo>
                    <a:pt x="15216" y="1958"/>
                  </a:lnTo>
                  <a:lnTo>
                    <a:pt x="7302" y="7286"/>
                  </a:lnTo>
                  <a:lnTo>
                    <a:pt x="1960" y="15162"/>
                  </a:lnTo>
                  <a:lnTo>
                    <a:pt x="0" y="24765"/>
                  </a:lnTo>
                  <a:lnTo>
                    <a:pt x="1960" y="34420"/>
                  </a:lnTo>
                  <a:lnTo>
                    <a:pt x="7302" y="42291"/>
                  </a:lnTo>
                  <a:lnTo>
                    <a:pt x="15216" y="47589"/>
                  </a:lnTo>
                  <a:lnTo>
                    <a:pt x="24892" y="49530"/>
                  </a:lnTo>
                  <a:lnTo>
                    <a:pt x="34494" y="47589"/>
                  </a:lnTo>
                  <a:lnTo>
                    <a:pt x="42370" y="42291"/>
                  </a:lnTo>
                  <a:lnTo>
                    <a:pt x="47698" y="34420"/>
                  </a:lnTo>
                  <a:lnTo>
                    <a:pt x="49657" y="24765"/>
                  </a:lnTo>
                  <a:lnTo>
                    <a:pt x="47698" y="15162"/>
                  </a:lnTo>
                  <a:lnTo>
                    <a:pt x="42370" y="7286"/>
                  </a:lnTo>
                  <a:lnTo>
                    <a:pt x="34494" y="1958"/>
                  </a:lnTo>
                  <a:lnTo>
                    <a:pt x="24892" y="0"/>
                  </a:lnTo>
                  <a:close/>
                </a:path>
              </a:pathLst>
            </a:custGeom>
            <a:solidFill>
              <a:srgbClr val="FF61CC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27" name="object 27"/>
            <p:cNvSpPr/>
            <p:nvPr/>
          </p:nvSpPr>
          <p:spPr>
            <a:xfrm>
              <a:off x="8893809" y="3933316"/>
              <a:ext cx="50165" cy="49530"/>
            </a:xfrm>
            <a:custGeom>
              <a:avLst/>
              <a:gdLst/>
              <a:ahLst/>
              <a:cxnLst/>
              <a:rect l="l" t="t" r="r" b="b"/>
              <a:pathLst>
                <a:path w="50165" h="49529">
                  <a:moveTo>
                    <a:pt x="0" y="24765"/>
                  </a:moveTo>
                  <a:lnTo>
                    <a:pt x="1960" y="15162"/>
                  </a:lnTo>
                  <a:lnTo>
                    <a:pt x="7302" y="7286"/>
                  </a:lnTo>
                  <a:lnTo>
                    <a:pt x="15216" y="1958"/>
                  </a:lnTo>
                  <a:lnTo>
                    <a:pt x="24892" y="0"/>
                  </a:lnTo>
                  <a:lnTo>
                    <a:pt x="34494" y="1958"/>
                  </a:lnTo>
                  <a:lnTo>
                    <a:pt x="42370" y="7286"/>
                  </a:lnTo>
                  <a:lnTo>
                    <a:pt x="47698" y="15162"/>
                  </a:lnTo>
                  <a:lnTo>
                    <a:pt x="49657" y="24765"/>
                  </a:lnTo>
                  <a:lnTo>
                    <a:pt x="47698" y="34420"/>
                  </a:lnTo>
                  <a:lnTo>
                    <a:pt x="42370" y="42291"/>
                  </a:lnTo>
                  <a:lnTo>
                    <a:pt x="34494" y="47589"/>
                  </a:lnTo>
                  <a:lnTo>
                    <a:pt x="24892" y="49530"/>
                  </a:lnTo>
                  <a:lnTo>
                    <a:pt x="15216" y="47589"/>
                  </a:lnTo>
                  <a:lnTo>
                    <a:pt x="7302" y="42291"/>
                  </a:lnTo>
                  <a:lnTo>
                    <a:pt x="1960" y="34420"/>
                  </a:lnTo>
                  <a:lnTo>
                    <a:pt x="0" y="2476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28" name="object 28"/>
          <p:cNvGrpSpPr/>
          <p:nvPr/>
        </p:nvGrpSpPr>
        <p:grpSpPr>
          <a:xfrm>
            <a:off x="8808973" y="4546853"/>
            <a:ext cx="219710" cy="1097280"/>
            <a:chOff x="8808973" y="4546853"/>
            <a:chExt cx="219710" cy="1097280"/>
          </a:xfrm>
        </p:grpSpPr>
        <p:sp>
          <p:nvSpPr>
            <p:cNvPr id="29" name="object 29"/>
            <p:cNvSpPr/>
            <p:nvPr/>
          </p:nvSpPr>
          <p:spPr>
            <a:xfrm>
              <a:off x="8808973" y="4546853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0" name="object 30"/>
            <p:cNvSpPr/>
            <p:nvPr/>
          </p:nvSpPr>
          <p:spPr>
            <a:xfrm>
              <a:off x="8903334" y="4641214"/>
              <a:ext cx="31115" cy="31115"/>
            </a:xfrm>
            <a:custGeom>
              <a:avLst/>
              <a:gdLst/>
              <a:ahLst/>
              <a:cxnLst/>
              <a:rect l="l" t="t" r="r" b="b"/>
              <a:pathLst>
                <a:path w="31115" h="31114">
                  <a:moveTo>
                    <a:pt x="0" y="15367"/>
                  </a:moveTo>
                  <a:lnTo>
                    <a:pt x="0" y="6858"/>
                  </a:lnTo>
                  <a:lnTo>
                    <a:pt x="6858" y="0"/>
                  </a:lnTo>
                  <a:lnTo>
                    <a:pt x="15367" y="0"/>
                  </a:lnTo>
                  <a:lnTo>
                    <a:pt x="23749" y="0"/>
                  </a:lnTo>
                  <a:lnTo>
                    <a:pt x="30607" y="6858"/>
                  </a:lnTo>
                  <a:lnTo>
                    <a:pt x="30607" y="15367"/>
                  </a:lnTo>
                  <a:lnTo>
                    <a:pt x="30607" y="23749"/>
                  </a:lnTo>
                  <a:lnTo>
                    <a:pt x="23749" y="30607"/>
                  </a:lnTo>
                  <a:lnTo>
                    <a:pt x="15367" y="30607"/>
                  </a:lnTo>
                  <a:lnTo>
                    <a:pt x="6858" y="30607"/>
                  </a:lnTo>
                  <a:lnTo>
                    <a:pt x="0" y="23749"/>
                  </a:lnTo>
                  <a:lnTo>
                    <a:pt x="0" y="15367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1" name="object 31"/>
            <p:cNvSpPr/>
            <p:nvPr/>
          </p:nvSpPr>
          <p:spPr>
            <a:xfrm>
              <a:off x="8808973" y="4766309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2" name="object 32"/>
            <p:cNvSpPr/>
            <p:nvPr/>
          </p:nvSpPr>
          <p:spPr>
            <a:xfrm>
              <a:off x="8874886" y="4832222"/>
              <a:ext cx="87630" cy="87630"/>
            </a:xfrm>
            <a:custGeom>
              <a:avLst/>
              <a:gdLst/>
              <a:ahLst/>
              <a:cxnLst/>
              <a:rect l="l" t="t" r="r" b="b"/>
              <a:pathLst>
                <a:path w="87629" h="87629">
                  <a:moveTo>
                    <a:pt x="0" y="43814"/>
                  </a:moveTo>
                  <a:lnTo>
                    <a:pt x="3452" y="26789"/>
                  </a:lnTo>
                  <a:lnTo>
                    <a:pt x="12858" y="12858"/>
                  </a:lnTo>
                  <a:lnTo>
                    <a:pt x="26789" y="3452"/>
                  </a:lnTo>
                  <a:lnTo>
                    <a:pt x="43815" y="0"/>
                  </a:lnTo>
                  <a:lnTo>
                    <a:pt x="60787" y="3452"/>
                  </a:lnTo>
                  <a:lnTo>
                    <a:pt x="74723" y="12858"/>
                  </a:lnTo>
                  <a:lnTo>
                    <a:pt x="84159" y="26789"/>
                  </a:lnTo>
                  <a:lnTo>
                    <a:pt x="87630" y="43814"/>
                  </a:lnTo>
                  <a:lnTo>
                    <a:pt x="84159" y="60767"/>
                  </a:lnTo>
                  <a:lnTo>
                    <a:pt x="74723" y="74660"/>
                  </a:lnTo>
                  <a:lnTo>
                    <a:pt x="60787" y="84052"/>
                  </a:lnTo>
                  <a:lnTo>
                    <a:pt x="43815" y="87502"/>
                  </a:lnTo>
                  <a:lnTo>
                    <a:pt x="26789" y="84052"/>
                  </a:lnTo>
                  <a:lnTo>
                    <a:pt x="12858" y="74660"/>
                  </a:lnTo>
                  <a:lnTo>
                    <a:pt x="3452" y="60767"/>
                  </a:lnTo>
                  <a:lnTo>
                    <a:pt x="0" y="43814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3" name="object 33"/>
            <p:cNvSpPr/>
            <p:nvPr/>
          </p:nvSpPr>
          <p:spPr>
            <a:xfrm>
              <a:off x="8808973" y="4985765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4" name="object 34"/>
            <p:cNvSpPr/>
            <p:nvPr/>
          </p:nvSpPr>
          <p:spPr>
            <a:xfrm>
              <a:off x="8863075" y="5039867"/>
              <a:ext cx="111125" cy="111125"/>
            </a:xfrm>
            <a:custGeom>
              <a:avLst/>
              <a:gdLst/>
              <a:ahLst/>
              <a:cxnLst/>
              <a:rect l="l" t="t" r="r" b="b"/>
              <a:pathLst>
                <a:path w="111125" h="111125">
                  <a:moveTo>
                    <a:pt x="0" y="55625"/>
                  </a:moveTo>
                  <a:lnTo>
                    <a:pt x="4387" y="34022"/>
                  </a:lnTo>
                  <a:lnTo>
                    <a:pt x="16335" y="16335"/>
                  </a:lnTo>
                  <a:lnTo>
                    <a:pt x="34022" y="4387"/>
                  </a:lnTo>
                  <a:lnTo>
                    <a:pt x="55625" y="0"/>
                  </a:lnTo>
                  <a:lnTo>
                    <a:pt x="77156" y="4387"/>
                  </a:lnTo>
                  <a:lnTo>
                    <a:pt x="94805" y="16335"/>
                  </a:lnTo>
                  <a:lnTo>
                    <a:pt x="106739" y="34022"/>
                  </a:lnTo>
                  <a:lnTo>
                    <a:pt x="111125" y="55625"/>
                  </a:lnTo>
                  <a:lnTo>
                    <a:pt x="106739" y="77156"/>
                  </a:lnTo>
                  <a:lnTo>
                    <a:pt x="94805" y="94805"/>
                  </a:lnTo>
                  <a:lnTo>
                    <a:pt x="77156" y="106739"/>
                  </a:lnTo>
                  <a:lnTo>
                    <a:pt x="55625" y="111124"/>
                  </a:lnTo>
                  <a:lnTo>
                    <a:pt x="34022" y="106739"/>
                  </a:lnTo>
                  <a:lnTo>
                    <a:pt x="16335" y="94805"/>
                  </a:lnTo>
                  <a:lnTo>
                    <a:pt x="4387" y="77156"/>
                  </a:lnTo>
                  <a:lnTo>
                    <a:pt x="0" y="55625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5" name="object 35"/>
            <p:cNvSpPr/>
            <p:nvPr/>
          </p:nvSpPr>
          <p:spPr>
            <a:xfrm>
              <a:off x="8808973" y="520522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5"/>
                  </a:lnTo>
                  <a:lnTo>
                    <a:pt x="219455" y="219455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6" name="object 36"/>
            <p:cNvSpPr/>
            <p:nvPr/>
          </p:nvSpPr>
          <p:spPr>
            <a:xfrm>
              <a:off x="8854058" y="5250306"/>
              <a:ext cx="129539" cy="129539"/>
            </a:xfrm>
            <a:custGeom>
              <a:avLst/>
              <a:gdLst/>
              <a:ahLst/>
              <a:cxnLst/>
              <a:rect l="l" t="t" r="r" b="b"/>
              <a:pathLst>
                <a:path w="129540" h="129539">
                  <a:moveTo>
                    <a:pt x="0" y="64643"/>
                  </a:moveTo>
                  <a:lnTo>
                    <a:pt x="5099" y="39540"/>
                  </a:lnTo>
                  <a:lnTo>
                    <a:pt x="18986" y="18986"/>
                  </a:lnTo>
                  <a:lnTo>
                    <a:pt x="39540" y="5099"/>
                  </a:lnTo>
                  <a:lnTo>
                    <a:pt x="64643" y="0"/>
                  </a:lnTo>
                  <a:lnTo>
                    <a:pt x="89745" y="5099"/>
                  </a:lnTo>
                  <a:lnTo>
                    <a:pt x="110299" y="18986"/>
                  </a:lnTo>
                  <a:lnTo>
                    <a:pt x="124186" y="39540"/>
                  </a:lnTo>
                  <a:lnTo>
                    <a:pt x="129286" y="64643"/>
                  </a:lnTo>
                  <a:lnTo>
                    <a:pt x="124186" y="89671"/>
                  </a:lnTo>
                  <a:lnTo>
                    <a:pt x="110299" y="110188"/>
                  </a:lnTo>
                  <a:lnTo>
                    <a:pt x="89745" y="124061"/>
                  </a:lnTo>
                  <a:lnTo>
                    <a:pt x="64643" y="129159"/>
                  </a:lnTo>
                  <a:lnTo>
                    <a:pt x="39540" y="124061"/>
                  </a:lnTo>
                  <a:lnTo>
                    <a:pt x="18986" y="110188"/>
                  </a:lnTo>
                  <a:lnTo>
                    <a:pt x="5099" y="89671"/>
                  </a:lnTo>
                  <a:lnTo>
                    <a:pt x="0" y="64643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7" name="object 37"/>
            <p:cNvSpPr/>
            <p:nvPr/>
          </p:nvSpPr>
          <p:spPr>
            <a:xfrm>
              <a:off x="8808973" y="5424677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38" name="object 38"/>
            <p:cNvSpPr/>
            <p:nvPr/>
          </p:nvSpPr>
          <p:spPr>
            <a:xfrm>
              <a:off x="8846438" y="5462142"/>
              <a:ext cx="144780" cy="144780"/>
            </a:xfrm>
            <a:custGeom>
              <a:avLst/>
              <a:gdLst/>
              <a:ahLst/>
              <a:cxnLst/>
              <a:rect l="l" t="t" r="r" b="b"/>
              <a:pathLst>
                <a:path w="144779" h="144779">
                  <a:moveTo>
                    <a:pt x="0" y="72262"/>
                  </a:moveTo>
                  <a:lnTo>
                    <a:pt x="5701" y="44201"/>
                  </a:lnTo>
                  <a:lnTo>
                    <a:pt x="21224" y="21224"/>
                  </a:lnTo>
                  <a:lnTo>
                    <a:pt x="44201" y="5701"/>
                  </a:lnTo>
                  <a:lnTo>
                    <a:pt x="72262" y="0"/>
                  </a:lnTo>
                  <a:lnTo>
                    <a:pt x="100324" y="5701"/>
                  </a:lnTo>
                  <a:lnTo>
                    <a:pt x="123301" y="21224"/>
                  </a:lnTo>
                  <a:lnTo>
                    <a:pt x="138824" y="44201"/>
                  </a:lnTo>
                  <a:lnTo>
                    <a:pt x="144525" y="72262"/>
                  </a:lnTo>
                  <a:lnTo>
                    <a:pt x="138824" y="100250"/>
                  </a:lnTo>
                  <a:lnTo>
                    <a:pt x="123301" y="123189"/>
                  </a:lnTo>
                  <a:lnTo>
                    <a:pt x="100324" y="138699"/>
                  </a:lnTo>
                  <a:lnTo>
                    <a:pt x="72262" y="144398"/>
                  </a:lnTo>
                  <a:lnTo>
                    <a:pt x="44201" y="138699"/>
                  </a:lnTo>
                  <a:lnTo>
                    <a:pt x="21224" y="123189"/>
                  </a:lnTo>
                  <a:lnTo>
                    <a:pt x="5701" y="100250"/>
                  </a:lnTo>
                  <a:lnTo>
                    <a:pt x="0" y="72262"/>
                  </a:lnTo>
                </a:path>
              </a:pathLst>
            </a:custGeom>
            <a:ln w="9017">
              <a:solidFill>
                <a:srgbClr val="666666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grpSp>
        <p:nvGrpSpPr>
          <p:cNvPr id="39" name="object 39"/>
          <p:cNvGrpSpPr/>
          <p:nvPr/>
        </p:nvGrpSpPr>
        <p:grpSpPr>
          <a:xfrm>
            <a:off x="8808973" y="6123051"/>
            <a:ext cx="219710" cy="219710"/>
            <a:chOff x="8808973" y="6123051"/>
            <a:chExt cx="219710" cy="219710"/>
          </a:xfrm>
        </p:grpSpPr>
        <p:sp>
          <p:nvSpPr>
            <p:cNvPr id="40" name="object 40"/>
            <p:cNvSpPr/>
            <p:nvPr/>
          </p:nvSpPr>
          <p:spPr>
            <a:xfrm>
              <a:off x="8808973" y="6123051"/>
              <a:ext cx="219710" cy="219710"/>
            </a:xfrm>
            <a:custGeom>
              <a:avLst/>
              <a:gdLst/>
              <a:ahLst/>
              <a:cxnLst/>
              <a:rect l="l" t="t" r="r" b="b"/>
              <a:pathLst>
                <a:path w="219709" h="219710">
                  <a:moveTo>
                    <a:pt x="219455" y="0"/>
                  </a:moveTo>
                  <a:lnTo>
                    <a:pt x="0" y="0"/>
                  </a:lnTo>
                  <a:lnTo>
                    <a:pt x="0" y="219456"/>
                  </a:lnTo>
                  <a:lnTo>
                    <a:pt x="219455" y="219456"/>
                  </a:lnTo>
                  <a:lnTo>
                    <a:pt x="219455" y="0"/>
                  </a:lnTo>
                  <a:close/>
                </a:path>
              </a:pathLst>
            </a:custGeom>
            <a:solidFill>
              <a:srgbClr val="F2F2F2"/>
            </a:solid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41" name="object 41"/>
            <p:cNvSpPr/>
            <p:nvPr/>
          </p:nvSpPr>
          <p:spPr>
            <a:xfrm>
              <a:off x="8830817" y="6232779"/>
              <a:ext cx="175895" cy="0"/>
            </a:xfrm>
            <a:custGeom>
              <a:avLst/>
              <a:gdLst/>
              <a:ahLst/>
              <a:cxnLst/>
              <a:rect l="l" t="t" r="r" b="b"/>
              <a:pathLst>
                <a:path w="175895">
                  <a:moveTo>
                    <a:pt x="0" y="0"/>
                  </a:moveTo>
                  <a:lnTo>
                    <a:pt x="175640" y="0"/>
                  </a:lnTo>
                </a:path>
              </a:pathLst>
            </a:custGeom>
            <a:ln w="3175">
              <a:solidFill>
                <a:srgbClr val="6D98B5"/>
              </a:solidFill>
            </a:ln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42" name="object 42"/>
          <p:cNvSpPr txBox="1"/>
          <p:nvPr/>
        </p:nvSpPr>
        <p:spPr>
          <a:xfrm>
            <a:off x="8796273" y="2074798"/>
            <a:ext cx="1136015" cy="423481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10" dirty="0">
                <a:latin typeface="Arial"/>
                <a:cs typeface="Arial"/>
              </a:rPr>
              <a:t>Phylum</a:t>
            </a:r>
            <a:endParaRPr sz="1100">
              <a:latin typeface="Arial"/>
              <a:cs typeface="Arial"/>
            </a:endParaRPr>
          </a:p>
          <a:p>
            <a:pPr marL="301625" marR="5080">
              <a:lnSpc>
                <a:spcPct val="160000"/>
              </a:lnSpc>
              <a:spcBef>
                <a:spcPts val="85"/>
              </a:spcBef>
            </a:pPr>
            <a:r>
              <a:rPr sz="900" dirty="0">
                <a:latin typeface="Arial"/>
                <a:cs typeface="Arial"/>
              </a:rPr>
              <a:t>Abditibacteriota </a:t>
            </a:r>
            <a:r>
              <a:rPr sz="900" spc="-23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Acidobacteriota </a:t>
            </a:r>
            <a:r>
              <a:rPr sz="900" spc="-23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Actinobacte</a:t>
            </a:r>
            <a:r>
              <a:rPr sz="900" spc="10" dirty="0">
                <a:latin typeface="Arial"/>
                <a:cs typeface="Arial"/>
              </a:rPr>
              <a:t>r</a:t>
            </a:r>
            <a:r>
              <a:rPr sz="900" dirty="0">
                <a:latin typeface="Arial"/>
                <a:cs typeface="Arial"/>
              </a:rPr>
              <a:t>iota  Bacteroidota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Bdellovibrionota </a:t>
            </a:r>
            <a:r>
              <a:rPr sz="900" spc="-235" dirty="0">
                <a:latin typeface="Arial"/>
                <a:cs typeface="Arial"/>
              </a:rPr>
              <a:t> </a:t>
            </a:r>
            <a:r>
              <a:rPr sz="900" spc="-5" dirty="0">
                <a:latin typeface="Arial"/>
                <a:cs typeface="Arial"/>
              </a:rPr>
              <a:t>Chloroflexi </a:t>
            </a:r>
            <a:r>
              <a:rPr sz="900" dirty="0">
                <a:latin typeface="Arial"/>
                <a:cs typeface="Arial"/>
              </a:rPr>
              <a:t> Firmicutes </a:t>
            </a:r>
            <a:r>
              <a:rPr sz="900" spc="5" dirty="0">
                <a:latin typeface="Arial"/>
                <a:cs typeface="Arial"/>
              </a:rPr>
              <a:t> </a:t>
            </a:r>
            <a:r>
              <a:rPr sz="900" dirty="0">
                <a:latin typeface="Arial"/>
                <a:cs typeface="Arial"/>
              </a:rPr>
              <a:t>Proteobacteria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100" spc="-5" dirty="0">
                <a:latin typeface="Arial"/>
                <a:cs typeface="Arial"/>
              </a:rPr>
              <a:t>igraph.degree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35"/>
              </a:spcBef>
            </a:pPr>
            <a:r>
              <a:rPr sz="900" dirty="0">
                <a:latin typeface="Arial"/>
                <a:cs typeface="Arial"/>
              </a:rPr>
              <a:t>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2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4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50"/>
              </a:spcBef>
            </a:pPr>
            <a:r>
              <a:rPr sz="900" dirty="0">
                <a:latin typeface="Arial"/>
                <a:cs typeface="Arial"/>
              </a:rPr>
              <a:t>60</a:t>
            </a:r>
            <a:endParaRPr sz="9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645"/>
              </a:spcBef>
            </a:pPr>
            <a:r>
              <a:rPr sz="900" dirty="0">
                <a:latin typeface="Arial"/>
                <a:cs typeface="Arial"/>
              </a:rPr>
              <a:t>80</a:t>
            </a:r>
            <a:endParaRPr sz="900">
              <a:latin typeface="Arial"/>
              <a:cs typeface="Arial"/>
            </a:endParaRPr>
          </a:p>
          <a:p>
            <a:pPr>
              <a:lnSpc>
                <a:spcPct val="100000"/>
              </a:lnSpc>
            </a:pPr>
            <a:endParaRPr sz="1000">
              <a:latin typeface="Arial"/>
              <a:cs typeface="Arial"/>
            </a:endParaRPr>
          </a:p>
          <a:p>
            <a:pPr>
              <a:lnSpc>
                <a:spcPct val="100000"/>
              </a:lnSpc>
              <a:spcBef>
                <a:spcPts val="5"/>
              </a:spcBef>
            </a:pPr>
            <a:endParaRPr sz="1050">
              <a:latin typeface="Arial"/>
              <a:cs typeface="Arial"/>
            </a:endParaRPr>
          </a:p>
          <a:p>
            <a:pPr marL="12700">
              <a:lnSpc>
                <a:spcPct val="100000"/>
              </a:lnSpc>
            </a:pPr>
            <a:r>
              <a:rPr sz="1100" dirty="0">
                <a:latin typeface="Arial"/>
                <a:cs typeface="Arial"/>
              </a:rPr>
              <a:t>cor</a:t>
            </a:r>
            <a:endParaRPr sz="1100">
              <a:latin typeface="Arial"/>
              <a:cs typeface="Arial"/>
            </a:endParaRPr>
          </a:p>
          <a:p>
            <a:pPr marL="301625">
              <a:lnSpc>
                <a:spcPct val="100000"/>
              </a:lnSpc>
              <a:spcBef>
                <a:spcPts val="740"/>
              </a:spcBef>
            </a:pPr>
            <a:r>
              <a:rPr sz="900" dirty="0">
                <a:latin typeface="Arial"/>
                <a:cs typeface="Arial"/>
              </a:rPr>
              <a:t>+</a:t>
            </a:r>
            <a:endParaRPr sz="900">
              <a:latin typeface="Arial"/>
              <a:cs typeface="Arial"/>
            </a:endParaRPr>
          </a:p>
        </p:txBody>
      </p:sp>
      <p:sp>
        <p:nvSpPr>
          <p:cNvPr id="43" name="object 43"/>
          <p:cNvSpPr txBox="1"/>
          <p:nvPr/>
        </p:nvSpPr>
        <p:spPr>
          <a:xfrm>
            <a:off x="3523488" y="10286"/>
            <a:ext cx="2572512" cy="2128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300" dirty="0" err="1">
                <a:latin typeface="Arial"/>
                <a:cs typeface="Arial"/>
              </a:rPr>
              <a:t>Bacteria_</a:t>
            </a:r>
            <a:r>
              <a:rPr sz="1300" dirty="0" err="1">
                <a:latin typeface="Arial"/>
                <a:cs typeface="Arial"/>
              </a:rPr>
              <a:t>GTD</a:t>
            </a:r>
            <a:r>
              <a:rPr sz="1300" spc="-80" dirty="0">
                <a:latin typeface="Arial"/>
                <a:cs typeface="Arial"/>
              </a:rPr>
              <a:t> </a:t>
            </a:r>
            <a:r>
              <a:rPr sz="1300" dirty="0">
                <a:latin typeface="Arial"/>
                <a:cs typeface="Arial"/>
              </a:rPr>
              <a:t>escape_network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Words>320</Words>
  <Application>Microsoft Office PowerPoint</Application>
  <PresentationFormat>Custom</PresentationFormat>
  <Paragraphs>77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Adejoro, Damola</cp:lastModifiedBy>
  <cp:revision>1</cp:revision>
  <dcterms:created xsi:type="dcterms:W3CDTF">2023-07-06T05:31:05Z</dcterms:created>
  <dcterms:modified xsi:type="dcterms:W3CDTF">2023-07-06T05:40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or">
    <vt:lpwstr>R</vt:lpwstr>
  </property>
</Properties>
</file>